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5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 smtClean="0"/>
              <a:t>10-14</a:t>
            </a:r>
            <a:r>
              <a:rPr lang="en-US" baseline="0" dirty="0" smtClean="0"/>
              <a:t> years ol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8.7473392710982284E-2"/>
          <c:y val="0.1018241469816273"/>
          <c:w val="0.89320434268031346"/>
          <c:h val="0.74557830271216097"/>
        </c:manualLayout>
      </c:layou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The number of influenza cases per week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C$2:$C$314</c:f>
              <c:numCache>
                <c:formatCode>General</c:formatCode>
                <c:ptCount val="313"/>
                <c:pt idx="0">
                  <c:v>145</c:v>
                </c:pt>
                <c:pt idx="1">
                  <c:v>377</c:v>
                </c:pt>
                <c:pt idx="2">
                  <c:v>1836</c:v>
                </c:pt>
                <c:pt idx="3">
                  <c:v>3023</c:v>
                </c:pt>
                <c:pt idx="4">
                  <c:v>2620</c:v>
                </c:pt>
                <c:pt idx="5">
                  <c:v>1645</c:v>
                </c:pt>
                <c:pt idx="6">
                  <c:v>1272</c:v>
                </c:pt>
                <c:pt idx="7">
                  <c:v>1041</c:v>
                </c:pt>
                <c:pt idx="8">
                  <c:v>846</c:v>
                </c:pt>
                <c:pt idx="9">
                  <c:v>822</c:v>
                </c:pt>
                <c:pt idx="10">
                  <c:v>815</c:v>
                </c:pt>
                <c:pt idx="11">
                  <c:v>668</c:v>
                </c:pt>
                <c:pt idx="12">
                  <c:v>397</c:v>
                </c:pt>
                <c:pt idx="13">
                  <c:v>141</c:v>
                </c:pt>
                <c:pt idx="14">
                  <c:v>131</c:v>
                </c:pt>
                <c:pt idx="15">
                  <c:v>167</c:v>
                </c:pt>
                <c:pt idx="16">
                  <c:v>124</c:v>
                </c:pt>
                <c:pt idx="17">
                  <c:v>19</c:v>
                </c:pt>
                <c:pt idx="18">
                  <c:v>17</c:v>
                </c:pt>
                <c:pt idx="19">
                  <c:v>7</c:v>
                </c:pt>
                <c:pt idx="20">
                  <c:v>4</c:v>
                </c:pt>
                <c:pt idx="21">
                  <c:v>4</c:v>
                </c:pt>
                <c:pt idx="22">
                  <c:v>1</c:v>
                </c:pt>
                <c:pt idx="23">
                  <c:v>0</c:v>
                </c:pt>
                <c:pt idx="24">
                  <c:v>1</c:v>
                </c:pt>
                <c:pt idx="25">
                  <c:v>1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2</c:v>
                </c:pt>
                <c:pt idx="33">
                  <c:v>1</c:v>
                </c:pt>
                <c:pt idx="34">
                  <c:v>1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1</c:v>
                </c:pt>
                <c:pt idx="45">
                  <c:v>2</c:v>
                </c:pt>
                <c:pt idx="46">
                  <c:v>4</c:v>
                </c:pt>
                <c:pt idx="47">
                  <c:v>7</c:v>
                </c:pt>
                <c:pt idx="48">
                  <c:v>19</c:v>
                </c:pt>
                <c:pt idx="49">
                  <c:v>17</c:v>
                </c:pt>
                <c:pt idx="50">
                  <c:v>32</c:v>
                </c:pt>
                <c:pt idx="51">
                  <c:v>31</c:v>
                </c:pt>
                <c:pt idx="52">
                  <c:v>29</c:v>
                </c:pt>
                <c:pt idx="53">
                  <c:v>175</c:v>
                </c:pt>
                <c:pt idx="54">
                  <c:v>481</c:v>
                </c:pt>
                <c:pt idx="55">
                  <c:v>1183</c:v>
                </c:pt>
                <c:pt idx="56">
                  <c:v>1315</c:v>
                </c:pt>
                <c:pt idx="57">
                  <c:v>1010</c:v>
                </c:pt>
                <c:pt idx="58">
                  <c:v>619</c:v>
                </c:pt>
                <c:pt idx="59">
                  <c:v>733</c:v>
                </c:pt>
                <c:pt idx="60">
                  <c:v>539</c:v>
                </c:pt>
                <c:pt idx="61">
                  <c:v>443</c:v>
                </c:pt>
                <c:pt idx="62">
                  <c:v>310</c:v>
                </c:pt>
                <c:pt idx="63">
                  <c:v>295</c:v>
                </c:pt>
                <c:pt idx="64">
                  <c:v>187</c:v>
                </c:pt>
                <c:pt idx="65">
                  <c:v>74</c:v>
                </c:pt>
                <c:pt idx="66">
                  <c:v>67</c:v>
                </c:pt>
                <c:pt idx="67">
                  <c:v>172</c:v>
                </c:pt>
                <c:pt idx="68">
                  <c:v>211</c:v>
                </c:pt>
                <c:pt idx="69">
                  <c:v>157</c:v>
                </c:pt>
                <c:pt idx="70">
                  <c:v>130</c:v>
                </c:pt>
                <c:pt idx="71">
                  <c:v>133</c:v>
                </c:pt>
                <c:pt idx="72">
                  <c:v>76</c:v>
                </c:pt>
                <c:pt idx="73">
                  <c:v>54</c:v>
                </c:pt>
                <c:pt idx="74">
                  <c:v>22</c:v>
                </c:pt>
                <c:pt idx="75">
                  <c:v>12</c:v>
                </c:pt>
                <c:pt idx="76">
                  <c:v>2</c:v>
                </c:pt>
                <c:pt idx="77">
                  <c:v>0</c:v>
                </c:pt>
                <c:pt idx="78">
                  <c:v>2</c:v>
                </c:pt>
                <c:pt idx="79">
                  <c:v>1</c:v>
                </c:pt>
                <c:pt idx="80">
                  <c:v>1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1</c:v>
                </c:pt>
                <c:pt idx="88">
                  <c:v>0</c:v>
                </c:pt>
                <c:pt idx="89">
                  <c:v>1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3</c:v>
                </c:pt>
                <c:pt idx="96">
                  <c:v>1</c:v>
                </c:pt>
                <c:pt idx="97">
                  <c:v>2</c:v>
                </c:pt>
                <c:pt idx="98">
                  <c:v>6</c:v>
                </c:pt>
                <c:pt idx="99">
                  <c:v>13</c:v>
                </c:pt>
                <c:pt idx="100">
                  <c:v>11</c:v>
                </c:pt>
                <c:pt idx="101">
                  <c:v>14</c:v>
                </c:pt>
                <c:pt idx="102">
                  <c:v>39</c:v>
                </c:pt>
                <c:pt idx="103">
                  <c:v>48</c:v>
                </c:pt>
                <c:pt idx="104">
                  <c:v>37</c:v>
                </c:pt>
                <c:pt idx="105">
                  <c:v>162</c:v>
                </c:pt>
                <c:pt idx="106">
                  <c:v>426</c:v>
                </c:pt>
                <c:pt idx="107">
                  <c:v>883</c:v>
                </c:pt>
                <c:pt idx="108">
                  <c:v>1272</c:v>
                </c:pt>
                <c:pt idx="109">
                  <c:v>1152</c:v>
                </c:pt>
                <c:pt idx="110">
                  <c:v>1087</c:v>
                </c:pt>
                <c:pt idx="111">
                  <c:v>1317</c:v>
                </c:pt>
                <c:pt idx="112">
                  <c:v>1548</c:v>
                </c:pt>
                <c:pt idx="113">
                  <c:v>1170</c:v>
                </c:pt>
                <c:pt idx="114">
                  <c:v>1312</c:v>
                </c:pt>
                <c:pt idx="115">
                  <c:v>1009</c:v>
                </c:pt>
                <c:pt idx="116">
                  <c:v>450</c:v>
                </c:pt>
                <c:pt idx="117">
                  <c:v>125</c:v>
                </c:pt>
                <c:pt idx="118">
                  <c:v>89</c:v>
                </c:pt>
                <c:pt idx="119">
                  <c:v>155</c:v>
                </c:pt>
                <c:pt idx="120">
                  <c:v>162</c:v>
                </c:pt>
                <c:pt idx="121">
                  <c:v>114</c:v>
                </c:pt>
                <c:pt idx="122">
                  <c:v>41</c:v>
                </c:pt>
                <c:pt idx="123">
                  <c:v>37</c:v>
                </c:pt>
                <c:pt idx="124">
                  <c:v>36</c:v>
                </c:pt>
                <c:pt idx="125">
                  <c:v>15</c:v>
                </c:pt>
                <c:pt idx="126">
                  <c:v>3</c:v>
                </c:pt>
                <c:pt idx="127">
                  <c:v>0</c:v>
                </c:pt>
                <c:pt idx="128">
                  <c:v>0</c:v>
                </c:pt>
                <c:pt idx="129">
                  <c:v>1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2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29</c:v>
                </c:pt>
                <c:pt idx="141">
                  <c:v>0</c:v>
                </c:pt>
                <c:pt idx="142">
                  <c:v>1</c:v>
                </c:pt>
                <c:pt idx="143">
                  <c:v>2</c:v>
                </c:pt>
                <c:pt idx="144">
                  <c:v>1</c:v>
                </c:pt>
                <c:pt idx="145">
                  <c:v>1</c:v>
                </c:pt>
                <c:pt idx="146">
                  <c:v>8</c:v>
                </c:pt>
                <c:pt idx="147">
                  <c:v>11</c:v>
                </c:pt>
                <c:pt idx="148">
                  <c:v>14</c:v>
                </c:pt>
                <c:pt idx="149">
                  <c:v>32</c:v>
                </c:pt>
                <c:pt idx="150">
                  <c:v>59</c:v>
                </c:pt>
                <c:pt idx="151">
                  <c:v>135</c:v>
                </c:pt>
                <c:pt idx="152">
                  <c:v>258</c:v>
                </c:pt>
                <c:pt idx="153">
                  <c:v>663</c:v>
                </c:pt>
                <c:pt idx="154">
                  <c:v>1662</c:v>
                </c:pt>
                <c:pt idx="155">
                  <c:v>2729</c:v>
                </c:pt>
                <c:pt idx="156">
                  <c:v>733</c:v>
                </c:pt>
                <c:pt idx="157">
                  <c:v>1009</c:v>
                </c:pt>
                <c:pt idx="158">
                  <c:v>1157</c:v>
                </c:pt>
                <c:pt idx="159">
                  <c:v>1454</c:v>
                </c:pt>
                <c:pt idx="160">
                  <c:v>1134</c:v>
                </c:pt>
                <c:pt idx="161">
                  <c:v>755</c:v>
                </c:pt>
                <c:pt idx="162">
                  <c:v>395</c:v>
                </c:pt>
                <c:pt idx="163">
                  <c:v>301</c:v>
                </c:pt>
                <c:pt idx="164">
                  <c:v>172</c:v>
                </c:pt>
                <c:pt idx="165">
                  <c:v>136</c:v>
                </c:pt>
                <c:pt idx="166">
                  <c:v>145</c:v>
                </c:pt>
                <c:pt idx="167">
                  <c:v>161</c:v>
                </c:pt>
                <c:pt idx="168">
                  <c:v>107</c:v>
                </c:pt>
                <c:pt idx="169">
                  <c:v>54</c:v>
                </c:pt>
                <c:pt idx="170">
                  <c:v>44</c:v>
                </c:pt>
                <c:pt idx="171">
                  <c:v>75</c:v>
                </c:pt>
                <c:pt idx="172">
                  <c:v>77</c:v>
                </c:pt>
                <c:pt idx="173">
                  <c:v>53</c:v>
                </c:pt>
                <c:pt idx="174">
                  <c:v>24</c:v>
                </c:pt>
                <c:pt idx="175">
                  <c:v>15</c:v>
                </c:pt>
                <c:pt idx="176">
                  <c:v>13</c:v>
                </c:pt>
                <c:pt idx="177">
                  <c:v>19</c:v>
                </c:pt>
                <c:pt idx="178">
                  <c:v>1</c:v>
                </c:pt>
                <c:pt idx="179">
                  <c:v>0</c:v>
                </c:pt>
                <c:pt idx="180">
                  <c:v>1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1</c:v>
                </c:pt>
                <c:pt idx="185">
                  <c:v>0</c:v>
                </c:pt>
                <c:pt idx="186">
                  <c:v>0</c:v>
                </c:pt>
                <c:pt idx="187">
                  <c:v>1</c:v>
                </c:pt>
                <c:pt idx="188">
                  <c:v>4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1</c:v>
                </c:pt>
                <c:pt idx="193">
                  <c:v>1</c:v>
                </c:pt>
                <c:pt idx="194">
                  <c:v>0</c:v>
                </c:pt>
                <c:pt idx="195">
                  <c:v>3</c:v>
                </c:pt>
                <c:pt idx="196">
                  <c:v>5</c:v>
                </c:pt>
                <c:pt idx="197">
                  <c:v>5</c:v>
                </c:pt>
                <c:pt idx="198">
                  <c:v>10</c:v>
                </c:pt>
                <c:pt idx="199">
                  <c:v>2</c:v>
                </c:pt>
                <c:pt idx="200">
                  <c:v>3</c:v>
                </c:pt>
                <c:pt idx="201">
                  <c:v>3</c:v>
                </c:pt>
                <c:pt idx="202">
                  <c:v>2</c:v>
                </c:pt>
                <c:pt idx="203">
                  <c:v>1</c:v>
                </c:pt>
                <c:pt idx="204">
                  <c:v>8</c:v>
                </c:pt>
                <c:pt idx="205">
                  <c:v>9</c:v>
                </c:pt>
                <c:pt idx="206">
                  <c:v>18</c:v>
                </c:pt>
                <c:pt idx="207">
                  <c:v>27</c:v>
                </c:pt>
                <c:pt idx="208">
                  <c:v>22</c:v>
                </c:pt>
                <c:pt idx="209">
                  <c:v>47</c:v>
                </c:pt>
                <c:pt idx="210">
                  <c:v>108</c:v>
                </c:pt>
                <c:pt idx="211">
                  <c:v>447</c:v>
                </c:pt>
                <c:pt idx="212">
                  <c:v>1067</c:v>
                </c:pt>
                <c:pt idx="213">
                  <c:v>1728</c:v>
                </c:pt>
                <c:pt idx="214">
                  <c:v>2224</c:v>
                </c:pt>
                <c:pt idx="215">
                  <c:v>2197</c:v>
                </c:pt>
                <c:pt idx="216">
                  <c:v>2143</c:v>
                </c:pt>
                <c:pt idx="217">
                  <c:v>1973</c:v>
                </c:pt>
                <c:pt idx="218">
                  <c:v>1290</c:v>
                </c:pt>
                <c:pt idx="219">
                  <c:v>798</c:v>
                </c:pt>
                <c:pt idx="220">
                  <c:v>444</c:v>
                </c:pt>
                <c:pt idx="221">
                  <c:v>237</c:v>
                </c:pt>
                <c:pt idx="222">
                  <c:v>103</c:v>
                </c:pt>
                <c:pt idx="223">
                  <c:v>56</c:v>
                </c:pt>
                <c:pt idx="224">
                  <c:v>47</c:v>
                </c:pt>
                <c:pt idx="225">
                  <c:v>23</c:v>
                </c:pt>
                <c:pt idx="226">
                  <c:v>13</c:v>
                </c:pt>
                <c:pt idx="227">
                  <c:v>7</c:v>
                </c:pt>
                <c:pt idx="228">
                  <c:v>7</c:v>
                </c:pt>
                <c:pt idx="229">
                  <c:v>2</c:v>
                </c:pt>
                <c:pt idx="230">
                  <c:v>1</c:v>
                </c:pt>
                <c:pt idx="231">
                  <c:v>2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1</c:v>
                </c:pt>
                <c:pt idx="237">
                  <c:v>1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1</c:v>
                </c:pt>
                <c:pt idx="242">
                  <c:v>0</c:v>
                </c:pt>
                <c:pt idx="243">
                  <c:v>0</c:v>
                </c:pt>
                <c:pt idx="244">
                  <c:v>1</c:v>
                </c:pt>
                <c:pt idx="245">
                  <c:v>1</c:v>
                </c:pt>
                <c:pt idx="246">
                  <c:v>0</c:v>
                </c:pt>
                <c:pt idx="247">
                  <c:v>0</c:v>
                </c:pt>
                <c:pt idx="248">
                  <c:v>1</c:v>
                </c:pt>
                <c:pt idx="249">
                  <c:v>8</c:v>
                </c:pt>
                <c:pt idx="250">
                  <c:v>4</c:v>
                </c:pt>
                <c:pt idx="251">
                  <c:v>1</c:v>
                </c:pt>
                <c:pt idx="252">
                  <c:v>8</c:v>
                </c:pt>
                <c:pt idx="253">
                  <c:v>14</c:v>
                </c:pt>
                <c:pt idx="254">
                  <c:v>48</c:v>
                </c:pt>
                <c:pt idx="255">
                  <c:v>81</c:v>
                </c:pt>
                <c:pt idx="256">
                  <c:v>89</c:v>
                </c:pt>
                <c:pt idx="257">
                  <c:v>89</c:v>
                </c:pt>
                <c:pt idx="258">
                  <c:v>160</c:v>
                </c:pt>
                <c:pt idx="259">
                  <c:v>298</c:v>
                </c:pt>
                <c:pt idx="260">
                  <c:v>230</c:v>
                </c:pt>
                <c:pt idx="261">
                  <c:v>246</c:v>
                </c:pt>
                <c:pt idx="262">
                  <c:v>530</c:v>
                </c:pt>
                <c:pt idx="263">
                  <c:v>1611</c:v>
                </c:pt>
                <c:pt idx="264">
                  <c:v>2662</c:v>
                </c:pt>
                <c:pt idx="265">
                  <c:v>2404</c:v>
                </c:pt>
                <c:pt idx="266">
                  <c:v>1450</c:v>
                </c:pt>
                <c:pt idx="267">
                  <c:v>1074</c:v>
                </c:pt>
                <c:pt idx="268">
                  <c:v>548</c:v>
                </c:pt>
                <c:pt idx="269">
                  <c:v>382</c:v>
                </c:pt>
                <c:pt idx="270">
                  <c:v>271</c:v>
                </c:pt>
                <c:pt idx="271">
                  <c:v>211</c:v>
                </c:pt>
                <c:pt idx="272">
                  <c:v>114</c:v>
                </c:pt>
                <c:pt idx="273">
                  <c:v>82</c:v>
                </c:pt>
                <c:pt idx="274">
                  <c:v>45</c:v>
                </c:pt>
                <c:pt idx="275">
                  <c:v>53</c:v>
                </c:pt>
                <c:pt idx="276">
                  <c:v>74</c:v>
                </c:pt>
                <c:pt idx="277">
                  <c:v>47</c:v>
                </c:pt>
                <c:pt idx="278">
                  <c:v>34</c:v>
                </c:pt>
                <c:pt idx="279">
                  <c:v>34</c:v>
                </c:pt>
                <c:pt idx="280">
                  <c:v>21</c:v>
                </c:pt>
                <c:pt idx="281">
                  <c:v>12</c:v>
                </c:pt>
                <c:pt idx="282">
                  <c:v>11</c:v>
                </c:pt>
                <c:pt idx="283">
                  <c:v>8</c:v>
                </c:pt>
                <c:pt idx="284">
                  <c:v>10</c:v>
                </c:pt>
                <c:pt idx="285">
                  <c:v>6</c:v>
                </c:pt>
                <c:pt idx="286">
                  <c:v>7</c:v>
                </c:pt>
                <c:pt idx="287">
                  <c:v>0</c:v>
                </c:pt>
                <c:pt idx="288">
                  <c:v>1</c:v>
                </c:pt>
                <c:pt idx="289">
                  <c:v>2</c:v>
                </c:pt>
                <c:pt idx="290">
                  <c:v>6</c:v>
                </c:pt>
                <c:pt idx="291">
                  <c:v>1</c:v>
                </c:pt>
                <c:pt idx="292">
                  <c:v>2</c:v>
                </c:pt>
                <c:pt idx="293">
                  <c:v>1</c:v>
                </c:pt>
                <c:pt idx="294">
                  <c:v>1</c:v>
                </c:pt>
                <c:pt idx="295">
                  <c:v>3</c:v>
                </c:pt>
                <c:pt idx="296">
                  <c:v>6</c:v>
                </c:pt>
                <c:pt idx="297">
                  <c:v>1</c:v>
                </c:pt>
                <c:pt idx="298">
                  <c:v>0</c:v>
                </c:pt>
                <c:pt idx="299">
                  <c:v>7</c:v>
                </c:pt>
                <c:pt idx="300">
                  <c:v>15</c:v>
                </c:pt>
                <c:pt idx="301">
                  <c:v>5</c:v>
                </c:pt>
                <c:pt idx="302">
                  <c:v>10</c:v>
                </c:pt>
                <c:pt idx="303">
                  <c:v>8</c:v>
                </c:pt>
                <c:pt idx="304">
                  <c:v>9</c:v>
                </c:pt>
                <c:pt idx="305">
                  <c:v>4</c:v>
                </c:pt>
                <c:pt idx="306">
                  <c:v>28</c:v>
                </c:pt>
                <c:pt idx="307">
                  <c:v>57</c:v>
                </c:pt>
                <c:pt idx="308">
                  <c:v>76</c:v>
                </c:pt>
                <c:pt idx="309">
                  <c:v>175</c:v>
                </c:pt>
                <c:pt idx="310">
                  <c:v>322</c:v>
                </c:pt>
                <c:pt idx="311">
                  <c:v>528</c:v>
                </c:pt>
                <c:pt idx="312">
                  <c:v>4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B3D-4EC0-A8D6-5E64F831BF17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The predict number of influenza patients calculated from regression model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E$2:$E$314</c:f>
              <c:numCache>
                <c:formatCode>General</c:formatCode>
                <c:ptCount val="313"/>
                <c:pt idx="0">
                  <c:v>182.49552140137877</c:v>
                </c:pt>
                <c:pt idx="1">
                  <c:v>871.63303964778129</c:v>
                </c:pt>
                <c:pt idx="2">
                  <c:v>1518.4727024533572</c:v>
                </c:pt>
                <c:pt idx="3">
                  <c:v>2578.3205392947589</c:v>
                </c:pt>
                <c:pt idx="4">
                  <c:v>2408.2585991195765</c:v>
                </c:pt>
                <c:pt idx="5">
                  <c:v>2101.7012440317681</c:v>
                </c:pt>
                <c:pt idx="6">
                  <c:v>1424.5100901728863</c:v>
                </c:pt>
                <c:pt idx="7">
                  <c:v>1255.2662968404363</c:v>
                </c:pt>
                <c:pt idx="8">
                  <c:v>1269.7830342091604</c:v>
                </c:pt>
                <c:pt idx="9">
                  <c:v>1133.6617335075455</c:v>
                </c:pt>
                <c:pt idx="10">
                  <c:v>1005.6231864905135</c:v>
                </c:pt>
                <c:pt idx="11">
                  <c:v>1163.3331484201758</c:v>
                </c:pt>
                <c:pt idx="12">
                  <c:v>413.75670473691906</c:v>
                </c:pt>
                <c:pt idx="13">
                  <c:v>203.94883526379289</c:v>
                </c:pt>
                <c:pt idx="14">
                  <c:v>272.16077000035642</c:v>
                </c:pt>
                <c:pt idx="15">
                  <c:v>186.00938771944527</c:v>
                </c:pt>
                <c:pt idx="16">
                  <c:v>178.34275368449715</c:v>
                </c:pt>
                <c:pt idx="17">
                  <c:v>79.201289824290257</c:v>
                </c:pt>
                <c:pt idx="18">
                  <c:v>9.02800000000002</c:v>
                </c:pt>
                <c:pt idx="19">
                  <c:v>-20.141864034591691</c:v>
                </c:pt>
                <c:pt idx="20">
                  <c:v>0.16287333413112037</c:v>
                </c:pt>
                <c:pt idx="21">
                  <c:v>12.598862456891595</c:v>
                </c:pt>
                <c:pt idx="22">
                  <c:v>-3.301842280112794</c:v>
                </c:pt>
                <c:pt idx="23">
                  <c:v>-38.939815087014466</c:v>
                </c:pt>
                <c:pt idx="24">
                  <c:v>-22.003825964253707</c:v>
                </c:pt>
                <c:pt idx="25">
                  <c:v>48.839458421502172</c:v>
                </c:pt>
                <c:pt idx="26">
                  <c:v>-99.081213683784085</c:v>
                </c:pt>
                <c:pt idx="27">
                  <c:v>24.169365964966687</c:v>
                </c:pt>
                <c:pt idx="28">
                  <c:v>232.79857964866608</c:v>
                </c:pt>
                <c:pt idx="29">
                  <c:v>294.84058508728543</c:v>
                </c:pt>
                <c:pt idx="30">
                  <c:v>99.580021754393954</c:v>
                </c:pt>
                <c:pt idx="31">
                  <c:v>-94.180672105371229</c:v>
                </c:pt>
                <c:pt idx="32">
                  <c:v>119.68257964866581</c:v>
                </c:pt>
                <c:pt idx="33">
                  <c:v>151.82081350931435</c:v>
                </c:pt>
                <c:pt idx="34">
                  <c:v>-8.8018096483946238</c:v>
                </c:pt>
                <c:pt idx="35">
                  <c:v>-31.805137543108231</c:v>
                </c:pt>
                <c:pt idx="36">
                  <c:v>-23.071229999643379</c:v>
                </c:pt>
                <c:pt idx="37">
                  <c:v>90.278710175539402</c:v>
                </c:pt>
                <c:pt idx="38">
                  <c:v>1.3327700003566179</c:v>
                </c:pt>
                <c:pt idx="39">
                  <c:v>-29.638503508160056</c:v>
                </c:pt>
                <c:pt idx="40">
                  <c:v>-15.769787893915748</c:v>
                </c:pt>
                <c:pt idx="41">
                  <c:v>-44.007219122403882</c:v>
                </c:pt>
                <c:pt idx="42">
                  <c:v>132.31751824631925</c:v>
                </c:pt>
                <c:pt idx="43">
                  <c:v>138.05149105322056</c:v>
                </c:pt>
                <c:pt idx="44">
                  <c:v>25.102157719887259</c:v>
                </c:pt>
                <c:pt idx="45">
                  <c:v>151.71815771988719</c:v>
                </c:pt>
                <c:pt idx="46">
                  <c:v>39.566710175539583</c:v>
                </c:pt>
                <c:pt idx="47">
                  <c:v>115.04137684220615</c:v>
                </c:pt>
                <c:pt idx="48">
                  <c:v>-25.017202806544844</c:v>
                </c:pt>
                <c:pt idx="49">
                  <c:v>102.81929526290986</c:v>
                </c:pt>
                <c:pt idx="50">
                  <c:v>107.5871647360355</c:v>
                </c:pt>
                <c:pt idx="51">
                  <c:v>248.08354315585569</c:v>
                </c:pt>
                <c:pt idx="52">
                  <c:v>-243.56447859862126</c:v>
                </c:pt>
                <c:pt idx="53">
                  <c:v>76.321039647781163</c:v>
                </c:pt>
                <c:pt idx="54">
                  <c:v>382.31270245335719</c:v>
                </c:pt>
                <c:pt idx="55">
                  <c:v>1243.3325392947588</c:v>
                </c:pt>
                <c:pt idx="56">
                  <c:v>1868.5825991195768</c:v>
                </c:pt>
                <c:pt idx="57">
                  <c:v>1249.5812440317684</c:v>
                </c:pt>
                <c:pt idx="58">
                  <c:v>998.45009017288635</c:v>
                </c:pt>
                <c:pt idx="59">
                  <c:v>857.61029684043638</c:v>
                </c:pt>
                <c:pt idx="60">
                  <c:v>758.51103420916024</c:v>
                </c:pt>
                <c:pt idx="61">
                  <c:v>508.7737335075455</c:v>
                </c:pt>
                <c:pt idx="62">
                  <c:v>522.75518649051355</c:v>
                </c:pt>
                <c:pt idx="63">
                  <c:v>566.84914842017565</c:v>
                </c:pt>
                <c:pt idx="64">
                  <c:v>356.94870473691907</c:v>
                </c:pt>
                <c:pt idx="65">
                  <c:v>61.928835263792905</c:v>
                </c:pt>
                <c:pt idx="66">
                  <c:v>16.524770000356398</c:v>
                </c:pt>
                <c:pt idx="67">
                  <c:v>186.00938771944527</c:v>
                </c:pt>
                <c:pt idx="68">
                  <c:v>7.9187536844971191</c:v>
                </c:pt>
                <c:pt idx="69">
                  <c:v>420.04928982429027</c:v>
                </c:pt>
                <c:pt idx="70">
                  <c:v>65.836000000000013</c:v>
                </c:pt>
                <c:pt idx="71">
                  <c:v>207.09013596540831</c:v>
                </c:pt>
                <c:pt idx="72">
                  <c:v>56.970873334131113</c:v>
                </c:pt>
                <c:pt idx="73">
                  <c:v>69.406862456891588</c:v>
                </c:pt>
                <c:pt idx="74">
                  <c:v>25.102157719887202</c:v>
                </c:pt>
                <c:pt idx="75">
                  <c:v>46.272184912985551</c:v>
                </c:pt>
                <c:pt idx="76">
                  <c:v>-22.003825964253707</c:v>
                </c:pt>
                <c:pt idx="77">
                  <c:v>-7.9685415784978204</c:v>
                </c:pt>
                <c:pt idx="78">
                  <c:v>-13.869213683784096</c:v>
                </c:pt>
                <c:pt idx="79">
                  <c:v>80.97736596496668</c:v>
                </c:pt>
                <c:pt idx="80">
                  <c:v>-108.04942035133394</c:v>
                </c:pt>
                <c:pt idx="81">
                  <c:v>-46.007414912714523</c:v>
                </c:pt>
                <c:pt idx="82">
                  <c:v>42.772021754393961</c:v>
                </c:pt>
                <c:pt idx="83">
                  <c:v>-236.20067210537121</c:v>
                </c:pt>
                <c:pt idx="84">
                  <c:v>62.874579648665815</c:v>
                </c:pt>
                <c:pt idx="85">
                  <c:v>-47.007186490685655</c:v>
                </c:pt>
                <c:pt idx="86">
                  <c:v>-65.609809648394616</c:v>
                </c:pt>
                <c:pt idx="87">
                  <c:v>25.002862456891762</c:v>
                </c:pt>
                <c:pt idx="88">
                  <c:v>-79.879229999643371</c:v>
                </c:pt>
                <c:pt idx="89">
                  <c:v>-108.5492898244606</c:v>
                </c:pt>
                <c:pt idx="90">
                  <c:v>-55.475229999643375</c:v>
                </c:pt>
                <c:pt idx="91">
                  <c:v>27.169496491839936</c:v>
                </c:pt>
                <c:pt idx="92">
                  <c:v>-44.173787893915744</c:v>
                </c:pt>
                <c:pt idx="93">
                  <c:v>-100.8152191224039</c:v>
                </c:pt>
                <c:pt idx="94">
                  <c:v>-66.510481753680722</c:v>
                </c:pt>
                <c:pt idx="95">
                  <c:v>-32.372508946779419</c:v>
                </c:pt>
                <c:pt idx="96">
                  <c:v>-88.513842280112755</c:v>
                </c:pt>
                <c:pt idx="97">
                  <c:v>-103.91784228011281</c:v>
                </c:pt>
                <c:pt idx="98">
                  <c:v>-45.645289824460434</c:v>
                </c:pt>
                <c:pt idx="99">
                  <c:v>-140.59462315779385</c:v>
                </c:pt>
                <c:pt idx="100">
                  <c:v>-25.017202806544844</c:v>
                </c:pt>
                <c:pt idx="101">
                  <c:v>46.011295262909869</c:v>
                </c:pt>
                <c:pt idx="102">
                  <c:v>79.183164736035508</c:v>
                </c:pt>
                <c:pt idx="103">
                  <c:v>162.87154315585565</c:v>
                </c:pt>
                <c:pt idx="104">
                  <c:v>-101.54447859862128</c:v>
                </c:pt>
                <c:pt idx="105">
                  <c:v>275.14903964778119</c:v>
                </c:pt>
                <c:pt idx="106">
                  <c:v>723.16070245335732</c:v>
                </c:pt>
                <c:pt idx="107">
                  <c:v>1442.1605392947588</c:v>
                </c:pt>
                <c:pt idx="108">
                  <c:v>1470.9265991195768</c:v>
                </c:pt>
                <c:pt idx="109">
                  <c:v>1135.9652440317684</c:v>
                </c:pt>
                <c:pt idx="110">
                  <c:v>1339.2980901728863</c:v>
                </c:pt>
                <c:pt idx="111">
                  <c:v>1141.6502968404363</c:v>
                </c:pt>
                <c:pt idx="112">
                  <c:v>985.74303420916044</c:v>
                </c:pt>
                <c:pt idx="113">
                  <c:v>821.21773350754552</c:v>
                </c:pt>
                <c:pt idx="114">
                  <c:v>863.60318649051351</c:v>
                </c:pt>
                <c:pt idx="115">
                  <c:v>538.44514842017566</c:v>
                </c:pt>
                <c:pt idx="116">
                  <c:v>271.73670473691908</c:v>
                </c:pt>
                <c:pt idx="117">
                  <c:v>33.524835263792852</c:v>
                </c:pt>
                <c:pt idx="118">
                  <c:v>44.928770000356394</c:v>
                </c:pt>
                <c:pt idx="119">
                  <c:v>100.79738771944523</c:v>
                </c:pt>
                <c:pt idx="120">
                  <c:v>93.130753684497108</c:v>
                </c:pt>
                <c:pt idx="121">
                  <c:v>-34.414710175709757</c:v>
                </c:pt>
                <c:pt idx="122">
                  <c:v>207.85599999999999</c:v>
                </c:pt>
                <c:pt idx="123">
                  <c:v>-105.35386403459171</c:v>
                </c:pt>
                <c:pt idx="124">
                  <c:v>28.566873334131117</c:v>
                </c:pt>
                <c:pt idx="125">
                  <c:v>-72.613137543108394</c:v>
                </c:pt>
                <c:pt idx="126">
                  <c:v>81.910157719887195</c:v>
                </c:pt>
                <c:pt idx="127">
                  <c:v>-10.535815087014441</c:v>
                </c:pt>
                <c:pt idx="128">
                  <c:v>34.804174035746257</c:v>
                </c:pt>
                <c:pt idx="129">
                  <c:v>-93.180541578497809</c:v>
                </c:pt>
                <c:pt idx="130">
                  <c:v>-13.869213683784096</c:v>
                </c:pt>
                <c:pt idx="131">
                  <c:v>-203.06263403503331</c:v>
                </c:pt>
                <c:pt idx="132">
                  <c:v>-221.66542035133395</c:v>
                </c:pt>
                <c:pt idx="133">
                  <c:v>-74.41141491271452</c:v>
                </c:pt>
                <c:pt idx="134">
                  <c:v>-184.45997824560607</c:v>
                </c:pt>
                <c:pt idx="135">
                  <c:v>-179.39267210537122</c:v>
                </c:pt>
                <c:pt idx="136">
                  <c:v>-192.76142035133415</c:v>
                </c:pt>
                <c:pt idx="137">
                  <c:v>-103.81518649068568</c:v>
                </c:pt>
                <c:pt idx="138">
                  <c:v>19.602190351605373</c:v>
                </c:pt>
                <c:pt idx="139">
                  <c:v>25.002862456891762</c:v>
                </c:pt>
                <c:pt idx="140">
                  <c:v>90.544770000356664</c:v>
                </c:pt>
                <c:pt idx="141">
                  <c:v>90.278710175539402</c:v>
                </c:pt>
                <c:pt idx="142">
                  <c:v>-27.071229999643379</c:v>
                </c:pt>
                <c:pt idx="143">
                  <c:v>27.169496491839936</c:v>
                </c:pt>
                <c:pt idx="144">
                  <c:v>-72.577787893915769</c:v>
                </c:pt>
                <c:pt idx="145">
                  <c:v>12.800780877596083</c:v>
                </c:pt>
                <c:pt idx="146">
                  <c:v>-9.7024817536807291</c:v>
                </c:pt>
                <c:pt idx="147">
                  <c:v>24.435491053220574</c:v>
                </c:pt>
                <c:pt idx="148">
                  <c:v>25.102157719887259</c:v>
                </c:pt>
                <c:pt idx="149">
                  <c:v>-75.513842280112812</c:v>
                </c:pt>
                <c:pt idx="150">
                  <c:v>-45.645289824460434</c:v>
                </c:pt>
                <c:pt idx="151">
                  <c:v>257.06137684220613</c:v>
                </c:pt>
                <c:pt idx="152">
                  <c:v>202.21479719345518</c:v>
                </c:pt>
                <c:pt idx="153">
                  <c:v>528.87929526290986</c:v>
                </c:pt>
                <c:pt idx="154">
                  <c:v>1243.7471647360355</c:v>
                </c:pt>
                <c:pt idx="155">
                  <c:v>2037.5355431558557</c:v>
                </c:pt>
                <c:pt idx="156">
                  <c:v>1517.4835214013788</c:v>
                </c:pt>
                <c:pt idx="157">
                  <c:v>530.7850396477811</c:v>
                </c:pt>
                <c:pt idx="158">
                  <c:v>1348.0487024533572</c:v>
                </c:pt>
                <c:pt idx="159">
                  <c:v>1555.7765392947588</c:v>
                </c:pt>
                <c:pt idx="160">
                  <c:v>1186.8865991195767</c:v>
                </c:pt>
                <c:pt idx="161">
                  <c:v>795.11724403176845</c:v>
                </c:pt>
                <c:pt idx="162">
                  <c:v>629.1980901728864</c:v>
                </c:pt>
                <c:pt idx="163">
                  <c:v>601.97429684043641</c:v>
                </c:pt>
                <c:pt idx="164">
                  <c:v>417.66303420916023</c:v>
                </c:pt>
                <c:pt idx="165">
                  <c:v>309.94573350754553</c:v>
                </c:pt>
                <c:pt idx="166">
                  <c:v>323.92718649051341</c:v>
                </c:pt>
                <c:pt idx="167">
                  <c:v>112.38514842017565</c:v>
                </c:pt>
                <c:pt idx="168">
                  <c:v>186.52470473691898</c:v>
                </c:pt>
                <c:pt idx="169">
                  <c:v>90.332835263792902</c:v>
                </c:pt>
                <c:pt idx="170">
                  <c:v>101.73677000035639</c:v>
                </c:pt>
                <c:pt idx="171">
                  <c:v>157.60538771944528</c:v>
                </c:pt>
                <c:pt idx="172">
                  <c:v>149.93875368449716</c:v>
                </c:pt>
                <c:pt idx="173">
                  <c:v>-91.22271017570975</c:v>
                </c:pt>
                <c:pt idx="174">
                  <c:v>9.02800000000002</c:v>
                </c:pt>
                <c:pt idx="175">
                  <c:v>8.2621359654082767</c:v>
                </c:pt>
                <c:pt idx="176">
                  <c:v>-85.049126665868869</c:v>
                </c:pt>
                <c:pt idx="177">
                  <c:v>-44.209137543108397</c:v>
                </c:pt>
                <c:pt idx="178">
                  <c:v>53.506157719887199</c:v>
                </c:pt>
                <c:pt idx="179">
                  <c:v>46.272184912985551</c:v>
                </c:pt>
                <c:pt idx="180">
                  <c:v>120.0161740357463</c:v>
                </c:pt>
                <c:pt idx="181">
                  <c:v>105.64745842150222</c:v>
                </c:pt>
                <c:pt idx="182">
                  <c:v>184.95878631621594</c:v>
                </c:pt>
                <c:pt idx="183">
                  <c:v>24.169365964966687</c:v>
                </c:pt>
                <c:pt idx="184">
                  <c:v>-22.837420351333947</c:v>
                </c:pt>
                <c:pt idx="185">
                  <c:v>-46.007414912714523</c:v>
                </c:pt>
                <c:pt idx="186">
                  <c:v>156.38802175439395</c:v>
                </c:pt>
                <c:pt idx="187">
                  <c:v>161.45532789462879</c:v>
                </c:pt>
                <c:pt idx="188">
                  <c:v>119.68257964866581</c:v>
                </c:pt>
                <c:pt idx="189">
                  <c:v>-47.007186490685655</c:v>
                </c:pt>
                <c:pt idx="190">
                  <c:v>19.602190351605373</c:v>
                </c:pt>
                <c:pt idx="191">
                  <c:v>25.002862456891762</c:v>
                </c:pt>
                <c:pt idx="192">
                  <c:v>-51.475229999643375</c:v>
                </c:pt>
                <c:pt idx="193">
                  <c:v>-23.337289824460612</c:v>
                </c:pt>
                <c:pt idx="194">
                  <c:v>256.96877000035664</c:v>
                </c:pt>
                <c:pt idx="195">
                  <c:v>-86.446503508160077</c:v>
                </c:pt>
                <c:pt idx="196">
                  <c:v>69.442212106084241</c:v>
                </c:pt>
                <c:pt idx="197">
                  <c:v>325.24478087759616</c:v>
                </c:pt>
                <c:pt idx="198">
                  <c:v>47.105518246319264</c:v>
                </c:pt>
                <c:pt idx="199">
                  <c:v>-89.18050894677944</c:v>
                </c:pt>
                <c:pt idx="200">
                  <c:v>25.102157719887259</c:v>
                </c:pt>
                <c:pt idx="201">
                  <c:v>38.102157719887202</c:v>
                </c:pt>
                <c:pt idx="202">
                  <c:v>266.7987101755395</c:v>
                </c:pt>
                <c:pt idx="203">
                  <c:v>115.04137684220615</c:v>
                </c:pt>
                <c:pt idx="204">
                  <c:v>60.194797193455145</c:v>
                </c:pt>
                <c:pt idx="205">
                  <c:v>17.607295262909872</c:v>
                </c:pt>
                <c:pt idx="206">
                  <c:v>135.9911647360355</c:v>
                </c:pt>
                <c:pt idx="207">
                  <c:v>191.27554315585564</c:v>
                </c:pt>
                <c:pt idx="208">
                  <c:v>21.998849296092089</c:v>
                </c:pt>
                <c:pt idx="209">
                  <c:v>-101.54447859862128</c:v>
                </c:pt>
                <c:pt idx="210">
                  <c:v>331.95703964778119</c:v>
                </c:pt>
                <c:pt idx="211">
                  <c:v>694.75670245335732</c:v>
                </c:pt>
                <c:pt idx="212">
                  <c:v>1640.9885392947588</c:v>
                </c:pt>
                <c:pt idx="213">
                  <c:v>1754.9665991195768</c:v>
                </c:pt>
                <c:pt idx="214">
                  <c:v>1846.0652440317683</c:v>
                </c:pt>
                <c:pt idx="215">
                  <c:v>1481.3180901728863</c:v>
                </c:pt>
                <c:pt idx="216">
                  <c:v>1510.9022968404365</c:v>
                </c:pt>
                <c:pt idx="217">
                  <c:v>1241.3790342091604</c:v>
                </c:pt>
                <c:pt idx="218">
                  <c:v>934.8337335075455</c:v>
                </c:pt>
                <c:pt idx="219">
                  <c:v>607.96718649051354</c:v>
                </c:pt>
                <c:pt idx="220">
                  <c:v>254.40514842017564</c:v>
                </c:pt>
                <c:pt idx="221">
                  <c:v>129.71670473691898</c:v>
                </c:pt>
                <c:pt idx="222">
                  <c:v>147.14083526379289</c:v>
                </c:pt>
                <c:pt idx="223">
                  <c:v>16.524770000356398</c:v>
                </c:pt>
                <c:pt idx="224">
                  <c:v>43.989387719445233</c:v>
                </c:pt>
                <c:pt idx="225">
                  <c:v>93.130753684497108</c:v>
                </c:pt>
                <c:pt idx="226">
                  <c:v>107.60528982429025</c:v>
                </c:pt>
                <c:pt idx="227">
                  <c:v>-76.183999999999997</c:v>
                </c:pt>
                <c:pt idx="228">
                  <c:v>150.28213596540832</c:v>
                </c:pt>
                <c:pt idx="229">
                  <c:v>56.970873334131113</c:v>
                </c:pt>
                <c:pt idx="230">
                  <c:v>126.21486245689158</c:v>
                </c:pt>
                <c:pt idx="231">
                  <c:v>-3.301842280112794</c:v>
                </c:pt>
                <c:pt idx="232">
                  <c:v>17.868184912985555</c:v>
                </c:pt>
                <c:pt idx="233">
                  <c:v>-50.407825964253732</c:v>
                </c:pt>
                <c:pt idx="234">
                  <c:v>-7.9685415784978204</c:v>
                </c:pt>
                <c:pt idx="235">
                  <c:v>-42.273213683784093</c:v>
                </c:pt>
                <c:pt idx="236">
                  <c:v>52.573365964966683</c:v>
                </c:pt>
                <c:pt idx="237">
                  <c:v>-22.837420351333947</c:v>
                </c:pt>
                <c:pt idx="238">
                  <c:v>-74.41141491271452</c:v>
                </c:pt>
                <c:pt idx="239">
                  <c:v>-42.439978245606056</c:v>
                </c:pt>
                <c:pt idx="240">
                  <c:v>303.47532789462883</c:v>
                </c:pt>
                <c:pt idx="241">
                  <c:v>34.470579648665819</c:v>
                </c:pt>
                <c:pt idx="242">
                  <c:v>66.608813509314302</c:v>
                </c:pt>
                <c:pt idx="243">
                  <c:v>48.006190351605369</c:v>
                </c:pt>
                <c:pt idx="244">
                  <c:v>-60.209137543108227</c:v>
                </c:pt>
                <c:pt idx="245">
                  <c:v>175.75677000035665</c:v>
                </c:pt>
                <c:pt idx="246">
                  <c:v>33.470710175539409</c:v>
                </c:pt>
                <c:pt idx="247">
                  <c:v>-27.071229999643379</c:v>
                </c:pt>
                <c:pt idx="248">
                  <c:v>112.38149649183993</c:v>
                </c:pt>
                <c:pt idx="249">
                  <c:v>126.25021210608423</c:v>
                </c:pt>
                <c:pt idx="250">
                  <c:v>-44.007219122403882</c:v>
                </c:pt>
                <c:pt idx="251">
                  <c:v>-66.510481753680722</c:v>
                </c:pt>
                <c:pt idx="252">
                  <c:v>52.83949105322057</c:v>
                </c:pt>
                <c:pt idx="253">
                  <c:v>167.12215771988724</c:v>
                </c:pt>
                <c:pt idx="254">
                  <c:v>180.12215771988718</c:v>
                </c:pt>
                <c:pt idx="255">
                  <c:v>11.16271017553953</c:v>
                </c:pt>
                <c:pt idx="256">
                  <c:v>29.829376842206159</c:v>
                </c:pt>
                <c:pt idx="257">
                  <c:v>202.21479719345518</c:v>
                </c:pt>
                <c:pt idx="258">
                  <c:v>273.24329526290984</c:v>
                </c:pt>
                <c:pt idx="259">
                  <c:v>476.83916473603546</c:v>
                </c:pt>
                <c:pt idx="260">
                  <c:v>390.10354315585568</c:v>
                </c:pt>
                <c:pt idx="261">
                  <c:v>-16.332478598621321</c:v>
                </c:pt>
                <c:pt idx="262">
                  <c:v>275.14903964778119</c:v>
                </c:pt>
                <c:pt idx="263">
                  <c:v>1291.2407024533572</c:v>
                </c:pt>
                <c:pt idx="264">
                  <c:v>1811.4125392947587</c:v>
                </c:pt>
                <c:pt idx="265">
                  <c:v>1783.3705991195768</c:v>
                </c:pt>
                <c:pt idx="266">
                  <c:v>1107.5612440317684</c:v>
                </c:pt>
                <c:pt idx="267">
                  <c:v>771.21809017288638</c:v>
                </c:pt>
                <c:pt idx="268">
                  <c:v>715.59029684043639</c:v>
                </c:pt>
                <c:pt idx="269">
                  <c:v>786.91503420916024</c:v>
                </c:pt>
                <c:pt idx="270">
                  <c:v>423.56173350754551</c:v>
                </c:pt>
                <c:pt idx="271">
                  <c:v>267.11918649051341</c:v>
                </c:pt>
                <c:pt idx="272">
                  <c:v>55.577148420175661</c:v>
                </c:pt>
                <c:pt idx="273">
                  <c:v>101.31270473691899</c:v>
                </c:pt>
                <c:pt idx="274">
                  <c:v>5.1208352637928556</c:v>
                </c:pt>
                <c:pt idx="275">
                  <c:v>-11.879229999643599</c:v>
                </c:pt>
                <c:pt idx="276">
                  <c:v>15.585387719445237</c:v>
                </c:pt>
                <c:pt idx="277">
                  <c:v>121.5347536844971</c:v>
                </c:pt>
                <c:pt idx="278">
                  <c:v>-91.22271017570975</c:v>
                </c:pt>
                <c:pt idx="279">
                  <c:v>37.432000000000016</c:v>
                </c:pt>
                <c:pt idx="280">
                  <c:v>-20.141864034591691</c:v>
                </c:pt>
                <c:pt idx="281">
                  <c:v>85.374873334131109</c:v>
                </c:pt>
                <c:pt idx="282">
                  <c:v>12.598862456891595</c:v>
                </c:pt>
                <c:pt idx="283">
                  <c:v>-116.91784228011278</c:v>
                </c:pt>
                <c:pt idx="284">
                  <c:v>-38.939815087014466</c:v>
                </c:pt>
                <c:pt idx="285">
                  <c:v>-50.407825964253732</c:v>
                </c:pt>
                <c:pt idx="286">
                  <c:v>-36.372541578497817</c:v>
                </c:pt>
                <c:pt idx="287">
                  <c:v>-13.869213683784096</c:v>
                </c:pt>
                <c:pt idx="288">
                  <c:v>24.169365964966687</c:v>
                </c:pt>
                <c:pt idx="289">
                  <c:v>147.58657964866609</c:v>
                </c:pt>
                <c:pt idx="290">
                  <c:v>-46.007414912714523</c:v>
                </c:pt>
                <c:pt idx="291">
                  <c:v>-70.843978245606053</c:v>
                </c:pt>
                <c:pt idx="292">
                  <c:v>47.839327894628809</c:v>
                </c:pt>
                <c:pt idx="293">
                  <c:v>-135.95342035133416</c:v>
                </c:pt>
                <c:pt idx="294">
                  <c:v>-18.603186490685687</c:v>
                </c:pt>
                <c:pt idx="295">
                  <c:v>-8.8018096483946238</c:v>
                </c:pt>
                <c:pt idx="296">
                  <c:v>25.002862456891762</c:v>
                </c:pt>
                <c:pt idx="297">
                  <c:v>-79.879229999643371</c:v>
                </c:pt>
                <c:pt idx="298">
                  <c:v>-80.145289824460605</c:v>
                </c:pt>
                <c:pt idx="299">
                  <c:v>-140.68722999964336</c:v>
                </c:pt>
                <c:pt idx="300">
                  <c:v>-29.638503508160056</c:v>
                </c:pt>
                <c:pt idx="301">
                  <c:v>-44.173787893915744</c:v>
                </c:pt>
                <c:pt idx="302">
                  <c:v>-129.2192191224039</c:v>
                </c:pt>
                <c:pt idx="303">
                  <c:v>-9.7024817536807291</c:v>
                </c:pt>
                <c:pt idx="304">
                  <c:v>-60.776508946779444</c:v>
                </c:pt>
                <c:pt idx="305">
                  <c:v>-116.91784228011275</c:v>
                </c:pt>
                <c:pt idx="306">
                  <c:v>-75.513842280112812</c:v>
                </c:pt>
                <c:pt idx="307">
                  <c:v>-17.241289824460466</c:v>
                </c:pt>
                <c:pt idx="308">
                  <c:v>-55.38262315779383</c:v>
                </c:pt>
                <c:pt idx="309">
                  <c:v>145.40679719345513</c:v>
                </c:pt>
                <c:pt idx="310">
                  <c:v>216.43529526290985</c:v>
                </c:pt>
                <c:pt idx="311">
                  <c:v>533.64716473603562</c:v>
                </c:pt>
                <c:pt idx="312">
                  <c:v>532.123543155855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B3D-4EC0-A8D6-5E64F831B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27113808"/>
        <c:axId val="1626116352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B$1</c15:sqref>
                        </c15:formulaRef>
                      </c:ext>
                    </c:extLst>
                    <c:strCache>
                      <c:ptCount val="1"/>
                      <c:pt idx="0">
                        <c:v>発熱トリアージ件数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B$2:$B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25</c:v>
                      </c:pt>
                      <c:pt idx="1">
                        <c:v>37</c:v>
                      </c:pt>
                      <c:pt idx="2">
                        <c:v>49</c:v>
                      </c:pt>
                      <c:pt idx="3">
                        <c:v>66</c:v>
                      </c:pt>
                      <c:pt idx="4">
                        <c:v>57</c:v>
                      </c:pt>
                      <c:pt idx="5">
                        <c:v>60</c:v>
                      </c:pt>
                      <c:pt idx="6">
                        <c:v>40</c:v>
                      </c:pt>
                      <c:pt idx="7">
                        <c:v>31</c:v>
                      </c:pt>
                      <c:pt idx="8">
                        <c:v>33</c:v>
                      </c:pt>
                      <c:pt idx="9">
                        <c:v>35</c:v>
                      </c:pt>
                      <c:pt idx="10">
                        <c:v>30</c:v>
                      </c:pt>
                      <c:pt idx="11">
                        <c:v>42</c:v>
                      </c:pt>
                      <c:pt idx="12">
                        <c:v>16</c:v>
                      </c:pt>
                      <c:pt idx="13">
                        <c:v>10</c:v>
                      </c:pt>
                      <c:pt idx="14">
                        <c:v>15</c:v>
                      </c:pt>
                      <c:pt idx="15">
                        <c:v>12</c:v>
                      </c:pt>
                      <c:pt idx="16">
                        <c:v>11</c:v>
                      </c:pt>
                      <c:pt idx="17">
                        <c:v>13</c:v>
                      </c:pt>
                      <c:pt idx="18">
                        <c:v>10</c:v>
                      </c:pt>
                      <c:pt idx="19">
                        <c:v>5</c:v>
                      </c:pt>
                      <c:pt idx="20">
                        <c:v>4</c:v>
                      </c:pt>
                      <c:pt idx="21">
                        <c:v>5</c:v>
                      </c:pt>
                      <c:pt idx="22">
                        <c:v>6</c:v>
                      </c:pt>
                      <c:pt idx="23">
                        <c:v>4</c:v>
                      </c:pt>
                      <c:pt idx="24">
                        <c:v>5</c:v>
                      </c:pt>
                      <c:pt idx="25">
                        <c:v>9</c:v>
                      </c:pt>
                      <c:pt idx="26">
                        <c:v>4</c:v>
                      </c:pt>
                      <c:pt idx="27">
                        <c:v>11</c:v>
                      </c:pt>
                      <c:pt idx="28">
                        <c:v>22</c:v>
                      </c:pt>
                      <c:pt idx="29">
                        <c:v>24</c:v>
                      </c:pt>
                      <c:pt idx="30">
                        <c:v>14</c:v>
                      </c:pt>
                      <c:pt idx="31">
                        <c:v>8</c:v>
                      </c:pt>
                      <c:pt idx="32">
                        <c:v>18</c:v>
                      </c:pt>
                      <c:pt idx="33">
                        <c:v>12</c:v>
                      </c:pt>
                      <c:pt idx="34">
                        <c:v>5</c:v>
                      </c:pt>
                      <c:pt idx="35">
                        <c:v>4</c:v>
                      </c:pt>
                      <c:pt idx="36">
                        <c:v>7</c:v>
                      </c:pt>
                      <c:pt idx="37">
                        <c:v>13</c:v>
                      </c:pt>
                      <c:pt idx="38">
                        <c:v>8</c:v>
                      </c:pt>
                      <c:pt idx="39">
                        <c:v>5</c:v>
                      </c:pt>
                      <c:pt idx="40">
                        <c:v>4</c:v>
                      </c:pt>
                      <c:pt idx="41">
                        <c:v>6</c:v>
                      </c:pt>
                      <c:pt idx="42">
                        <c:v>10</c:v>
                      </c:pt>
                      <c:pt idx="43">
                        <c:v>11</c:v>
                      </c:pt>
                      <c:pt idx="44">
                        <c:v>7</c:v>
                      </c:pt>
                      <c:pt idx="45">
                        <c:v>11</c:v>
                      </c:pt>
                      <c:pt idx="46">
                        <c:v>10</c:v>
                      </c:pt>
                      <c:pt idx="47">
                        <c:v>12</c:v>
                      </c:pt>
                      <c:pt idx="48">
                        <c:v>3</c:v>
                      </c:pt>
                      <c:pt idx="49">
                        <c:v>9</c:v>
                      </c:pt>
                      <c:pt idx="50">
                        <c:v>5</c:v>
                      </c:pt>
                      <c:pt idx="51">
                        <c:v>13</c:v>
                      </c:pt>
                      <c:pt idx="52">
                        <c:v>10</c:v>
                      </c:pt>
                      <c:pt idx="53">
                        <c:v>9</c:v>
                      </c:pt>
                      <c:pt idx="54">
                        <c:v>9</c:v>
                      </c:pt>
                      <c:pt idx="55">
                        <c:v>19</c:v>
                      </c:pt>
                      <c:pt idx="56">
                        <c:v>38</c:v>
                      </c:pt>
                      <c:pt idx="57">
                        <c:v>30</c:v>
                      </c:pt>
                      <c:pt idx="58">
                        <c:v>25</c:v>
                      </c:pt>
                      <c:pt idx="59">
                        <c:v>17</c:v>
                      </c:pt>
                      <c:pt idx="60">
                        <c:v>15</c:v>
                      </c:pt>
                      <c:pt idx="61">
                        <c:v>13</c:v>
                      </c:pt>
                      <c:pt idx="62">
                        <c:v>13</c:v>
                      </c:pt>
                      <c:pt idx="63">
                        <c:v>21</c:v>
                      </c:pt>
                      <c:pt idx="64">
                        <c:v>14</c:v>
                      </c:pt>
                      <c:pt idx="65">
                        <c:v>5</c:v>
                      </c:pt>
                      <c:pt idx="66">
                        <c:v>6</c:v>
                      </c:pt>
                      <c:pt idx="67">
                        <c:v>12</c:v>
                      </c:pt>
                      <c:pt idx="68">
                        <c:v>5</c:v>
                      </c:pt>
                      <c:pt idx="69">
                        <c:v>25</c:v>
                      </c:pt>
                      <c:pt idx="70">
                        <c:v>12</c:v>
                      </c:pt>
                      <c:pt idx="71">
                        <c:v>13</c:v>
                      </c:pt>
                      <c:pt idx="72">
                        <c:v>6</c:v>
                      </c:pt>
                      <c:pt idx="73">
                        <c:v>7</c:v>
                      </c:pt>
                      <c:pt idx="74">
                        <c:v>7</c:v>
                      </c:pt>
                      <c:pt idx="75">
                        <c:v>7</c:v>
                      </c:pt>
                      <c:pt idx="76">
                        <c:v>5</c:v>
                      </c:pt>
                      <c:pt idx="77">
                        <c:v>7</c:v>
                      </c:pt>
                      <c:pt idx="78">
                        <c:v>7</c:v>
                      </c:pt>
                      <c:pt idx="79">
                        <c:v>13</c:v>
                      </c:pt>
                      <c:pt idx="80">
                        <c:v>10</c:v>
                      </c:pt>
                      <c:pt idx="81">
                        <c:v>12</c:v>
                      </c:pt>
                      <c:pt idx="82">
                        <c:v>12</c:v>
                      </c:pt>
                      <c:pt idx="83">
                        <c:v>3</c:v>
                      </c:pt>
                      <c:pt idx="84">
                        <c:v>16</c:v>
                      </c:pt>
                      <c:pt idx="85">
                        <c:v>5</c:v>
                      </c:pt>
                      <c:pt idx="86">
                        <c:v>3</c:v>
                      </c:pt>
                      <c:pt idx="87">
                        <c:v>6</c:v>
                      </c:pt>
                      <c:pt idx="88">
                        <c:v>5</c:v>
                      </c:pt>
                      <c:pt idx="89">
                        <c:v>6</c:v>
                      </c:pt>
                      <c:pt idx="90">
                        <c:v>6</c:v>
                      </c:pt>
                      <c:pt idx="91">
                        <c:v>7</c:v>
                      </c:pt>
                      <c:pt idx="92">
                        <c:v>3</c:v>
                      </c:pt>
                      <c:pt idx="93">
                        <c:v>4</c:v>
                      </c:pt>
                      <c:pt idx="94">
                        <c:v>3</c:v>
                      </c:pt>
                      <c:pt idx="95">
                        <c:v>5</c:v>
                      </c:pt>
                      <c:pt idx="96">
                        <c:v>3</c:v>
                      </c:pt>
                      <c:pt idx="97">
                        <c:v>2</c:v>
                      </c:pt>
                      <c:pt idx="98">
                        <c:v>7</c:v>
                      </c:pt>
                      <c:pt idx="99">
                        <c:v>3</c:v>
                      </c:pt>
                      <c:pt idx="100">
                        <c:v>3</c:v>
                      </c:pt>
                      <c:pt idx="101">
                        <c:v>7</c:v>
                      </c:pt>
                      <c:pt idx="102">
                        <c:v>4</c:v>
                      </c:pt>
                      <c:pt idx="103">
                        <c:v>10</c:v>
                      </c:pt>
                      <c:pt idx="104">
                        <c:v>15</c:v>
                      </c:pt>
                      <c:pt idx="105">
                        <c:v>16</c:v>
                      </c:pt>
                      <c:pt idx="106">
                        <c:v>21</c:v>
                      </c:pt>
                      <c:pt idx="107">
                        <c:v>26</c:v>
                      </c:pt>
                      <c:pt idx="108">
                        <c:v>24</c:v>
                      </c:pt>
                      <c:pt idx="109">
                        <c:v>26</c:v>
                      </c:pt>
                      <c:pt idx="110">
                        <c:v>37</c:v>
                      </c:pt>
                      <c:pt idx="111">
                        <c:v>27</c:v>
                      </c:pt>
                      <c:pt idx="112">
                        <c:v>23</c:v>
                      </c:pt>
                      <c:pt idx="113">
                        <c:v>24</c:v>
                      </c:pt>
                      <c:pt idx="114">
                        <c:v>25</c:v>
                      </c:pt>
                      <c:pt idx="115">
                        <c:v>20</c:v>
                      </c:pt>
                      <c:pt idx="116">
                        <c:v>11</c:v>
                      </c:pt>
                      <c:pt idx="117">
                        <c:v>4</c:v>
                      </c:pt>
                      <c:pt idx="118">
                        <c:v>7</c:v>
                      </c:pt>
                      <c:pt idx="119">
                        <c:v>9</c:v>
                      </c:pt>
                      <c:pt idx="120">
                        <c:v>8</c:v>
                      </c:pt>
                      <c:pt idx="121">
                        <c:v>9</c:v>
                      </c:pt>
                      <c:pt idx="122">
                        <c:v>17</c:v>
                      </c:pt>
                      <c:pt idx="123">
                        <c:v>2</c:v>
                      </c:pt>
                      <c:pt idx="124">
                        <c:v>5</c:v>
                      </c:pt>
                      <c:pt idx="125">
                        <c:v>2</c:v>
                      </c:pt>
                      <c:pt idx="126">
                        <c:v>9</c:v>
                      </c:pt>
                      <c:pt idx="127">
                        <c:v>5</c:v>
                      </c:pt>
                      <c:pt idx="128">
                        <c:v>7</c:v>
                      </c:pt>
                      <c:pt idx="129">
                        <c:v>4</c:v>
                      </c:pt>
                      <c:pt idx="130">
                        <c:v>7</c:v>
                      </c:pt>
                      <c:pt idx="131">
                        <c:v>3</c:v>
                      </c:pt>
                      <c:pt idx="132">
                        <c:v>6</c:v>
                      </c:pt>
                      <c:pt idx="133">
                        <c:v>11</c:v>
                      </c:pt>
                      <c:pt idx="134">
                        <c:v>4</c:v>
                      </c:pt>
                      <c:pt idx="135">
                        <c:v>5</c:v>
                      </c:pt>
                      <c:pt idx="136">
                        <c:v>7</c:v>
                      </c:pt>
                      <c:pt idx="137">
                        <c:v>3</c:v>
                      </c:pt>
                      <c:pt idx="138">
                        <c:v>6</c:v>
                      </c:pt>
                      <c:pt idx="139">
                        <c:v>6</c:v>
                      </c:pt>
                      <c:pt idx="140">
                        <c:v>11</c:v>
                      </c:pt>
                      <c:pt idx="141">
                        <c:v>13</c:v>
                      </c:pt>
                      <c:pt idx="142">
                        <c:v>7</c:v>
                      </c:pt>
                      <c:pt idx="143">
                        <c:v>7</c:v>
                      </c:pt>
                      <c:pt idx="144">
                        <c:v>2</c:v>
                      </c:pt>
                      <c:pt idx="145">
                        <c:v>8</c:v>
                      </c:pt>
                      <c:pt idx="146">
                        <c:v>5</c:v>
                      </c:pt>
                      <c:pt idx="147">
                        <c:v>7</c:v>
                      </c:pt>
                      <c:pt idx="148">
                        <c:v>7</c:v>
                      </c:pt>
                      <c:pt idx="149">
                        <c:v>3</c:v>
                      </c:pt>
                      <c:pt idx="150">
                        <c:v>7</c:v>
                      </c:pt>
                      <c:pt idx="151">
                        <c:v>17</c:v>
                      </c:pt>
                      <c:pt idx="152">
                        <c:v>11</c:v>
                      </c:pt>
                      <c:pt idx="153">
                        <c:v>24</c:v>
                      </c:pt>
                      <c:pt idx="154">
                        <c:v>45</c:v>
                      </c:pt>
                      <c:pt idx="155">
                        <c:v>76</c:v>
                      </c:pt>
                      <c:pt idx="156">
                        <c:v>72</c:v>
                      </c:pt>
                      <c:pt idx="157">
                        <c:v>25</c:v>
                      </c:pt>
                      <c:pt idx="158">
                        <c:v>43</c:v>
                      </c:pt>
                      <c:pt idx="159">
                        <c:v>30</c:v>
                      </c:pt>
                      <c:pt idx="160">
                        <c:v>14</c:v>
                      </c:pt>
                      <c:pt idx="161">
                        <c:v>14</c:v>
                      </c:pt>
                      <c:pt idx="162">
                        <c:v>12</c:v>
                      </c:pt>
                      <c:pt idx="163">
                        <c:v>8</c:v>
                      </c:pt>
                      <c:pt idx="164">
                        <c:v>3</c:v>
                      </c:pt>
                      <c:pt idx="165">
                        <c:v>6</c:v>
                      </c:pt>
                      <c:pt idx="166">
                        <c:v>6</c:v>
                      </c:pt>
                      <c:pt idx="167">
                        <c:v>5</c:v>
                      </c:pt>
                      <c:pt idx="168">
                        <c:v>8</c:v>
                      </c:pt>
                      <c:pt idx="169">
                        <c:v>6</c:v>
                      </c:pt>
                      <c:pt idx="170">
                        <c:v>9</c:v>
                      </c:pt>
                      <c:pt idx="171">
                        <c:v>11</c:v>
                      </c:pt>
                      <c:pt idx="172">
                        <c:v>10</c:v>
                      </c:pt>
                      <c:pt idx="173">
                        <c:v>7</c:v>
                      </c:pt>
                      <c:pt idx="174">
                        <c:v>10</c:v>
                      </c:pt>
                      <c:pt idx="175">
                        <c:v>6</c:v>
                      </c:pt>
                      <c:pt idx="176">
                        <c:v>1</c:v>
                      </c:pt>
                      <c:pt idx="177">
                        <c:v>3</c:v>
                      </c:pt>
                      <c:pt idx="178">
                        <c:v>8</c:v>
                      </c:pt>
                      <c:pt idx="179">
                        <c:v>7</c:v>
                      </c:pt>
                      <c:pt idx="180">
                        <c:v>10</c:v>
                      </c:pt>
                      <c:pt idx="181">
                        <c:v>11</c:v>
                      </c:pt>
                      <c:pt idx="182">
                        <c:v>14</c:v>
                      </c:pt>
                      <c:pt idx="183">
                        <c:v>11</c:v>
                      </c:pt>
                      <c:pt idx="184">
                        <c:v>13</c:v>
                      </c:pt>
                      <c:pt idx="185">
                        <c:v>12</c:v>
                      </c:pt>
                      <c:pt idx="186">
                        <c:v>16</c:v>
                      </c:pt>
                      <c:pt idx="187">
                        <c:v>17</c:v>
                      </c:pt>
                      <c:pt idx="188">
                        <c:v>18</c:v>
                      </c:pt>
                      <c:pt idx="189">
                        <c:v>5</c:v>
                      </c:pt>
                      <c:pt idx="190">
                        <c:v>6</c:v>
                      </c:pt>
                      <c:pt idx="191">
                        <c:v>6</c:v>
                      </c:pt>
                      <c:pt idx="192">
                        <c:v>6</c:v>
                      </c:pt>
                      <c:pt idx="193">
                        <c:v>9</c:v>
                      </c:pt>
                      <c:pt idx="194">
                        <c:v>17</c:v>
                      </c:pt>
                      <c:pt idx="195">
                        <c:v>3</c:v>
                      </c:pt>
                      <c:pt idx="196">
                        <c:v>7</c:v>
                      </c:pt>
                      <c:pt idx="197">
                        <c:v>19</c:v>
                      </c:pt>
                      <c:pt idx="198">
                        <c:v>7</c:v>
                      </c:pt>
                      <c:pt idx="199">
                        <c:v>3</c:v>
                      </c:pt>
                      <c:pt idx="200">
                        <c:v>7</c:v>
                      </c:pt>
                      <c:pt idx="201">
                        <c:v>7</c:v>
                      </c:pt>
                      <c:pt idx="202">
                        <c:v>18</c:v>
                      </c:pt>
                      <c:pt idx="203">
                        <c:v>12</c:v>
                      </c:pt>
                      <c:pt idx="204">
                        <c:v>6</c:v>
                      </c:pt>
                      <c:pt idx="205">
                        <c:v>6</c:v>
                      </c:pt>
                      <c:pt idx="206">
                        <c:v>6</c:v>
                      </c:pt>
                      <c:pt idx="207">
                        <c:v>11</c:v>
                      </c:pt>
                      <c:pt idx="208">
                        <c:v>26</c:v>
                      </c:pt>
                      <c:pt idx="209">
                        <c:v>15</c:v>
                      </c:pt>
                      <c:pt idx="210">
                        <c:v>18</c:v>
                      </c:pt>
                      <c:pt idx="211">
                        <c:v>20</c:v>
                      </c:pt>
                      <c:pt idx="212">
                        <c:v>33</c:v>
                      </c:pt>
                      <c:pt idx="213">
                        <c:v>34</c:v>
                      </c:pt>
                      <c:pt idx="214">
                        <c:v>51</c:v>
                      </c:pt>
                      <c:pt idx="215">
                        <c:v>42</c:v>
                      </c:pt>
                      <c:pt idx="216">
                        <c:v>40</c:v>
                      </c:pt>
                      <c:pt idx="217">
                        <c:v>32</c:v>
                      </c:pt>
                      <c:pt idx="218">
                        <c:v>28</c:v>
                      </c:pt>
                      <c:pt idx="219">
                        <c:v>16</c:v>
                      </c:pt>
                      <c:pt idx="220">
                        <c:v>10</c:v>
                      </c:pt>
                      <c:pt idx="221">
                        <c:v>6</c:v>
                      </c:pt>
                      <c:pt idx="222">
                        <c:v>8</c:v>
                      </c:pt>
                      <c:pt idx="223">
                        <c:v>6</c:v>
                      </c:pt>
                      <c:pt idx="224">
                        <c:v>7</c:v>
                      </c:pt>
                      <c:pt idx="225">
                        <c:v>8</c:v>
                      </c:pt>
                      <c:pt idx="226">
                        <c:v>14</c:v>
                      </c:pt>
                      <c:pt idx="227">
                        <c:v>7</c:v>
                      </c:pt>
                      <c:pt idx="228">
                        <c:v>11</c:v>
                      </c:pt>
                      <c:pt idx="229">
                        <c:v>6</c:v>
                      </c:pt>
                      <c:pt idx="230">
                        <c:v>9</c:v>
                      </c:pt>
                      <c:pt idx="231">
                        <c:v>6</c:v>
                      </c:pt>
                      <c:pt idx="232">
                        <c:v>6</c:v>
                      </c:pt>
                      <c:pt idx="233">
                        <c:v>4</c:v>
                      </c:pt>
                      <c:pt idx="234">
                        <c:v>7</c:v>
                      </c:pt>
                      <c:pt idx="235">
                        <c:v>6</c:v>
                      </c:pt>
                      <c:pt idx="236">
                        <c:v>12</c:v>
                      </c:pt>
                      <c:pt idx="237">
                        <c:v>13</c:v>
                      </c:pt>
                      <c:pt idx="238">
                        <c:v>11</c:v>
                      </c:pt>
                      <c:pt idx="239">
                        <c:v>9</c:v>
                      </c:pt>
                      <c:pt idx="240">
                        <c:v>22</c:v>
                      </c:pt>
                      <c:pt idx="241">
                        <c:v>15</c:v>
                      </c:pt>
                      <c:pt idx="242">
                        <c:v>9</c:v>
                      </c:pt>
                      <c:pt idx="243">
                        <c:v>7</c:v>
                      </c:pt>
                      <c:pt idx="244">
                        <c:v>3</c:v>
                      </c:pt>
                      <c:pt idx="245">
                        <c:v>14</c:v>
                      </c:pt>
                      <c:pt idx="246">
                        <c:v>11</c:v>
                      </c:pt>
                      <c:pt idx="247">
                        <c:v>7</c:v>
                      </c:pt>
                      <c:pt idx="248">
                        <c:v>10</c:v>
                      </c:pt>
                      <c:pt idx="249">
                        <c:v>9</c:v>
                      </c:pt>
                      <c:pt idx="250">
                        <c:v>6</c:v>
                      </c:pt>
                      <c:pt idx="251">
                        <c:v>3</c:v>
                      </c:pt>
                      <c:pt idx="252">
                        <c:v>8</c:v>
                      </c:pt>
                      <c:pt idx="253">
                        <c:v>12</c:v>
                      </c:pt>
                      <c:pt idx="254">
                        <c:v>12</c:v>
                      </c:pt>
                      <c:pt idx="255">
                        <c:v>9</c:v>
                      </c:pt>
                      <c:pt idx="256">
                        <c:v>9</c:v>
                      </c:pt>
                      <c:pt idx="257">
                        <c:v>11</c:v>
                      </c:pt>
                      <c:pt idx="258">
                        <c:v>15</c:v>
                      </c:pt>
                      <c:pt idx="259">
                        <c:v>18</c:v>
                      </c:pt>
                      <c:pt idx="260">
                        <c:v>18</c:v>
                      </c:pt>
                      <c:pt idx="261">
                        <c:v>18</c:v>
                      </c:pt>
                      <c:pt idx="262">
                        <c:v>16</c:v>
                      </c:pt>
                      <c:pt idx="263">
                        <c:v>41</c:v>
                      </c:pt>
                      <c:pt idx="264">
                        <c:v>39</c:v>
                      </c:pt>
                      <c:pt idx="265">
                        <c:v>35</c:v>
                      </c:pt>
                      <c:pt idx="266">
                        <c:v>25</c:v>
                      </c:pt>
                      <c:pt idx="267">
                        <c:v>17</c:v>
                      </c:pt>
                      <c:pt idx="268">
                        <c:v>12</c:v>
                      </c:pt>
                      <c:pt idx="269">
                        <c:v>16</c:v>
                      </c:pt>
                      <c:pt idx="270">
                        <c:v>10</c:v>
                      </c:pt>
                      <c:pt idx="271">
                        <c:v>4</c:v>
                      </c:pt>
                      <c:pt idx="272">
                        <c:v>3</c:v>
                      </c:pt>
                      <c:pt idx="273">
                        <c:v>5</c:v>
                      </c:pt>
                      <c:pt idx="274">
                        <c:v>3</c:v>
                      </c:pt>
                      <c:pt idx="275">
                        <c:v>5</c:v>
                      </c:pt>
                      <c:pt idx="276">
                        <c:v>6</c:v>
                      </c:pt>
                      <c:pt idx="277">
                        <c:v>9</c:v>
                      </c:pt>
                      <c:pt idx="278">
                        <c:v>7</c:v>
                      </c:pt>
                      <c:pt idx="279">
                        <c:v>11</c:v>
                      </c:pt>
                      <c:pt idx="280">
                        <c:v>5</c:v>
                      </c:pt>
                      <c:pt idx="281">
                        <c:v>7</c:v>
                      </c:pt>
                      <c:pt idx="282">
                        <c:v>5</c:v>
                      </c:pt>
                      <c:pt idx="283">
                        <c:v>2</c:v>
                      </c:pt>
                      <c:pt idx="284">
                        <c:v>4</c:v>
                      </c:pt>
                      <c:pt idx="285">
                        <c:v>4</c:v>
                      </c:pt>
                      <c:pt idx="286">
                        <c:v>6</c:v>
                      </c:pt>
                      <c:pt idx="287">
                        <c:v>7</c:v>
                      </c:pt>
                      <c:pt idx="288">
                        <c:v>11</c:v>
                      </c:pt>
                      <c:pt idx="289">
                        <c:v>19</c:v>
                      </c:pt>
                      <c:pt idx="290">
                        <c:v>12</c:v>
                      </c:pt>
                      <c:pt idx="291">
                        <c:v>8</c:v>
                      </c:pt>
                      <c:pt idx="292">
                        <c:v>13</c:v>
                      </c:pt>
                      <c:pt idx="293">
                        <c:v>9</c:v>
                      </c:pt>
                      <c:pt idx="294">
                        <c:v>6</c:v>
                      </c:pt>
                      <c:pt idx="295">
                        <c:v>5</c:v>
                      </c:pt>
                      <c:pt idx="296">
                        <c:v>6</c:v>
                      </c:pt>
                      <c:pt idx="297">
                        <c:v>5</c:v>
                      </c:pt>
                      <c:pt idx="298">
                        <c:v>7</c:v>
                      </c:pt>
                      <c:pt idx="299">
                        <c:v>3</c:v>
                      </c:pt>
                      <c:pt idx="300">
                        <c:v>5</c:v>
                      </c:pt>
                      <c:pt idx="301">
                        <c:v>3</c:v>
                      </c:pt>
                      <c:pt idx="302">
                        <c:v>3</c:v>
                      </c:pt>
                      <c:pt idx="303">
                        <c:v>5</c:v>
                      </c:pt>
                      <c:pt idx="304">
                        <c:v>4</c:v>
                      </c:pt>
                      <c:pt idx="305">
                        <c:v>2</c:v>
                      </c:pt>
                      <c:pt idx="306">
                        <c:v>3</c:v>
                      </c:pt>
                      <c:pt idx="307">
                        <c:v>8</c:v>
                      </c:pt>
                      <c:pt idx="308">
                        <c:v>6</c:v>
                      </c:pt>
                      <c:pt idx="309">
                        <c:v>9</c:v>
                      </c:pt>
                      <c:pt idx="310">
                        <c:v>13</c:v>
                      </c:pt>
                      <c:pt idx="311">
                        <c:v>20</c:v>
                      </c:pt>
                      <c:pt idx="312">
                        <c:v>23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1B3D-4EC0-A8D6-5E64F831BF17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1</c15:sqref>
                        </c15:formulaRef>
                      </c:ext>
                    </c:extLst>
                    <c:strCache>
                      <c:ptCount val="1"/>
                      <c:pt idx="0">
                        <c:v>Week係数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2:$D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-252.59247859862128</c:v>
                      </c:pt>
                      <c:pt idx="1">
                        <c:v>95.697039647781182</c:v>
                      </c:pt>
                      <c:pt idx="2">
                        <c:v>401.68870245335717</c:v>
                      </c:pt>
                      <c:pt idx="3">
                        <c:v>978.66853929475883</c:v>
                      </c:pt>
                      <c:pt idx="4">
                        <c:v>1064.2425991195767</c:v>
                      </c:pt>
                      <c:pt idx="5">
                        <c:v>672.47324403176833</c:v>
                      </c:pt>
                      <c:pt idx="6">
                        <c:v>563.36209017288627</c:v>
                      </c:pt>
                      <c:pt idx="7">
                        <c:v>649.75429684043638</c:v>
                      </c:pt>
                      <c:pt idx="8">
                        <c:v>607.46303420916024</c:v>
                      </c:pt>
                      <c:pt idx="9">
                        <c:v>414.53373350754555</c:v>
                      </c:pt>
                      <c:pt idx="10">
                        <c:v>428.51518649051343</c:v>
                      </c:pt>
                      <c:pt idx="11">
                        <c:v>245.37714842017567</c:v>
                      </c:pt>
                      <c:pt idx="12">
                        <c:v>234.30470473691901</c:v>
                      </c:pt>
                      <c:pt idx="13">
                        <c:v>194.92083526379287</c:v>
                      </c:pt>
                      <c:pt idx="14">
                        <c:v>121.11277000035638</c:v>
                      </c:pt>
                      <c:pt idx="15">
                        <c:v>120.17338771944524</c:v>
                      </c:pt>
                      <c:pt idx="16">
                        <c:v>140.91075368449711</c:v>
                      </c:pt>
                      <c:pt idx="17">
                        <c:v>-15.038710175709763</c:v>
                      </c:pt>
                      <c:pt idx="18">
                        <c:v>0</c:v>
                      </c:pt>
                      <c:pt idx="19">
                        <c:v>112.8501359654083</c:v>
                      </c:pt>
                      <c:pt idx="20">
                        <c:v>161.55887333413114</c:v>
                      </c:pt>
                      <c:pt idx="21">
                        <c:v>145.59086245689161</c:v>
                      </c:pt>
                      <c:pt idx="22">
                        <c:v>101.28615771988721</c:v>
                      </c:pt>
                      <c:pt idx="23">
                        <c:v>122.45618491298553</c:v>
                      </c:pt>
                      <c:pt idx="24">
                        <c:v>110.98817403574628</c:v>
                      </c:pt>
                      <c:pt idx="25">
                        <c:v>68.215458421502177</c:v>
                      </c:pt>
                      <c:pt idx="26">
                        <c:v>62.314786316215901</c:v>
                      </c:pt>
                      <c:pt idx="27">
                        <c:v>-13.262634035033321</c:v>
                      </c:pt>
                      <c:pt idx="28">
                        <c:v>-117.07742035133396</c:v>
                      </c:pt>
                      <c:pt idx="29">
                        <c:v>-111.84341491271454</c:v>
                      </c:pt>
                      <c:pt idx="30">
                        <c:v>-23.063978245606062</c:v>
                      </c:pt>
                      <c:pt idx="31">
                        <c:v>-46.400672105371214</c:v>
                      </c:pt>
                      <c:pt idx="32">
                        <c:v>-116.57742035133417</c:v>
                      </c:pt>
                      <c:pt idx="33">
                        <c:v>85.984813509314336</c:v>
                      </c:pt>
                      <c:pt idx="34">
                        <c:v>124.19019035160538</c:v>
                      </c:pt>
                      <c:pt idx="35">
                        <c:v>129.59086245689176</c:v>
                      </c:pt>
                      <c:pt idx="36">
                        <c:v>53.112770000356619</c:v>
                      </c:pt>
                      <c:pt idx="37">
                        <c:v>-3.9612898244606112</c:v>
                      </c:pt>
                      <c:pt idx="38">
                        <c:v>49.112770000356626</c:v>
                      </c:pt>
                      <c:pt idx="39">
                        <c:v>103.35349649183992</c:v>
                      </c:pt>
                      <c:pt idx="40">
                        <c:v>145.62621210608424</c:v>
                      </c:pt>
                      <c:pt idx="41">
                        <c:v>60.580780877596112</c:v>
                      </c:pt>
                      <c:pt idx="42">
                        <c:v>123.28951824631926</c:v>
                      </c:pt>
                      <c:pt idx="43">
                        <c:v>100.61949105322056</c:v>
                      </c:pt>
                      <c:pt idx="44">
                        <c:v>101.28615771988724</c:v>
                      </c:pt>
                      <c:pt idx="45">
                        <c:v>114.28615771988719</c:v>
                      </c:pt>
                      <c:pt idx="46">
                        <c:v>30.538710175539556</c:v>
                      </c:pt>
                      <c:pt idx="47">
                        <c:v>49.205376842206157</c:v>
                      </c:pt>
                      <c:pt idx="48">
                        <c:v>164.78279719345517</c:v>
                      </c:pt>
                      <c:pt idx="49">
                        <c:v>122.19529526290984</c:v>
                      </c:pt>
                      <c:pt idx="50">
                        <c:v>240.57916473603549</c:v>
                      </c:pt>
                      <c:pt idx="51">
                        <c:v>153.84354315585563</c:v>
                      </c:pt>
                      <c:pt idx="52">
                        <c:v>-252.59247859862128</c:v>
                      </c:pt>
                      <c:pt idx="53">
                        <c:v>95.697039647781182</c:v>
                      </c:pt>
                      <c:pt idx="54">
                        <c:v>401.68870245335717</c:v>
                      </c:pt>
                      <c:pt idx="55">
                        <c:v>978.66853929475883</c:v>
                      </c:pt>
                      <c:pt idx="56">
                        <c:v>1064.2425991195767</c:v>
                      </c:pt>
                      <c:pt idx="57">
                        <c:v>672.47324403176833</c:v>
                      </c:pt>
                      <c:pt idx="58">
                        <c:v>563.36209017288627</c:v>
                      </c:pt>
                      <c:pt idx="59">
                        <c:v>649.75429684043638</c:v>
                      </c:pt>
                      <c:pt idx="60">
                        <c:v>607.46303420916024</c:v>
                      </c:pt>
                      <c:pt idx="61">
                        <c:v>414.53373350754555</c:v>
                      </c:pt>
                      <c:pt idx="62">
                        <c:v>428.51518649051343</c:v>
                      </c:pt>
                      <c:pt idx="63">
                        <c:v>245.37714842017567</c:v>
                      </c:pt>
                      <c:pt idx="64">
                        <c:v>234.30470473691901</c:v>
                      </c:pt>
                      <c:pt idx="65">
                        <c:v>194.92083526379287</c:v>
                      </c:pt>
                      <c:pt idx="66">
                        <c:v>121.11277000035638</c:v>
                      </c:pt>
                      <c:pt idx="67">
                        <c:v>120.17338771944524</c:v>
                      </c:pt>
                      <c:pt idx="68">
                        <c:v>140.91075368449711</c:v>
                      </c:pt>
                      <c:pt idx="69">
                        <c:v>-15.038710175709763</c:v>
                      </c:pt>
                      <c:pt idx="70">
                        <c:v>0</c:v>
                      </c:pt>
                      <c:pt idx="71">
                        <c:v>112.8501359654083</c:v>
                      </c:pt>
                      <c:pt idx="72">
                        <c:v>161.55887333413114</c:v>
                      </c:pt>
                      <c:pt idx="73">
                        <c:v>145.59086245689161</c:v>
                      </c:pt>
                      <c:pt idx="74">
                        <c:v>101.28615771988721</c:v>
                      </c:pt>
                      <c:pt idx="75">
                        <c:v>122.45618491298553</c:v>
                      </c:pt>
                      <c:pt idx="76">
                        <c:v>110.98817403574628</c:v>
                      </c:pt>
                      <c:pt idx="77">
                        <c:v>68.215458421502177</c:v>
                      </c:pt>
                      <c:pt idx="78">
                        <c:v>62.314786316215901</c:v>
                      </c:pt>
                      <c:pt idx="79">
                        <c:v>-13.262634035033321</c:v>
                      </c:pt>
                      <c:pt idx="80">
                        <c:v>-117.07742035133396</c:v>
                      </c:pt>
                      <c:pt idx="81">
                        <c:v>-111.84341491271454</c:v>
                      </c:pt>
                      <c:pt idx="82">
                        <c:v>-23.063978245606062</c:v>
                      </c:pt>
                      <c:pt idx="83">
                        <c:v>-46.400672105371214</c:v>
                      </c:pt>
                      <c:pt idx="84">
                        <c:v>-116.57742035133417</c:v>
                      </c:pt>
                      <c:pt idx="85">
                        <c:v>85.984813509314336</c:v>
                      </c:pt>
                      <c:pt idx="86">
                        <c:v>124.19019035160538</c:v>
                      </c:pt>
                      <c:pt idx="87">
                        <c:v>129.59086245689176</c:v>
                      </c:pt>
                      <c:pt idx="88">
                        <c:v>53.112770000356619</c:v>
                      </c:pt>
                      <c:pt idx="89">
                        <c:v>-3.9612898244606112</c:v>
                      </c:pt>
                      <c:pt idx="90">
                        <c:v>49.112770000356626</c:v>
                      </c:pt>
                      <c:pt idx="91">
                        <c:v>103.35349649183992</c:v>
                      </c:pt>
                      <c:pt idx="92">
                        <c:v>145.62621210608424</c:v>
                      </c:pt>
                      <c:pt idx="93">
                        <c:v>60.580780877596112</c:v>
                      </c:pt>
                      <c:pt idx="94">
                        <c:v>123.28951824631926</c:v>
                      </c:pt>
                      <c:pt idx="95">
                        <c:v>100.61949105322056</c:v>
                      </c:pt>
                      <c:pt idx="96">
                        <c:v>101.28615771988724</c:v>
                      </c:pt>
                      <c:pt idx="97">
                        <c:v>114.28615771988719</c:v>
                      </c:pt>
                      <c:pt idx="98">
                        <c:v>30.538710175539556</c:v>
                      </c:pt>
                      <c:pt idx="99">
                        <c:v>49.205376842206157</c:v>
                      </c:pt>
                      <c:pt idx="100">
                        <c:v>164.78279719345517</c:v>
                      </c:pt>
                      <c:pt idx="101">
                        <c:v>122.19529526290984</c:v>
                      </c:pt>
                      <c:pt idx="102">
                        <c:v>240.57916473603549</c:v>
                      </c:pt>
                      <c:pt idx="103">
                        <c:v>153.84354315585563</c:v>
                      </c:pt>
                      <c:pt idx="104">
                        <c:v>-252.59247859862128</c:v>
                      </c:pt>
                      <c:pt idx="105">
                        <c:v>95.697039647781182</c:v>
                      </c:pt>
                      <c:pt idx="106">
                        <c:v>401.68870245335717</c:v>
                      </c:pt>
                      <c:pt idx="107">
                        <c:v>978.66853929475883</c:v>
                      </c:pt>
                      <c:pt idx="108">
                        <c:v>1064.2425991195767</c:v>
                      </c:pt>
                      <c:pt idx="109">
                        <c:v>672.47324403176833</c:v>
                      </c:pt>
                      <c:pt idx="110">
                        <c:v>563.36209017288627</c:v>
                      </c:pt>
                      <c:pt idx="111">
                        <c:v>649.75429684043638</c:v>
                      </c:pt>
                      <c:pt idx="112">
                        <c:v>607.46303420916024</c:v>
                      </c:pt>
                      <c:pt idx="113">
                        <c:v>414.53373350754555</c:v>
                      </c:pt>
                      <c:pt idx="114">
                        <c:v>428.51518649051343</c:v>
                      </c:pt>
                      <c:pt idx="115">
                        <c:v>245.37714842017567</c:v>
                      </c:pt>
                      <c:pt idx="116">
                        <c:v>234.30470473691901</c:v>
                      </c:pt>
                      <c:pt idx="117">
                        <c:v>194.92083526379287</c:v>
                      </c:pt>
                      <c:pt idx="118">
                        <c:v>121.11277000035638</c:v>
                      </c:pt>
                      <c:pt idx="119">
                        <c:v>120.17338771944524</c:v>
                      </c:pt>
                      <c:pt idx="120">
                        <c:v>140.91075368449711</c:v>
                      </c:pt>
                      <c:pt idx="121">
                        <c:v>-15.038710175709763</c:v>
                      </c:pt>
                      <c:pt idx="122">
                        <c:v>0</c:v>
                      </c:pt>
                      <c:pt idx="123">
                        <c:v>112.8501359654083</c:v>
                      </c:pt>
                      <c:pt idx="124">
                        <c:v>161.55887333413114</c:v>
                      </c:pt>
                      <c:pt idx="125">
                        <c:v>145.59086245689161</c:v>
                      </c:pt>
                      <c:pt idx="126">
                        <c:v>101.28615771988721</c:v>
                      </c:pt>
                      <c:pt idx="127">
                        <c:v>122.45618491298553</c:v>
                      </c:pt>
                      <c:pt idx="128">
                        <c:v>110.98817403574628</c:v>
                      </c:pt>
                      <c:pt idx="129">
                        <c:v>68.215458421502177</c:v>
                      </c:pt>
                      <c:pt idx="130">
                        <c:v>62.314786316215901</c:v>
                      </c:pt>
                      <c:pt idx="131">
                        <c:v>-13.262634035033321</c:v>
                      </c:pt>
                      <c:pt idx="132">
                        <c:v>-117.07742035133396</c:v>
                      </c:pt>
                      <c:pt idx="133">
                        <c:v>-111.84341491271454</c:v>
                      </c:pt>
                      <c:pt idx="134">
                        <c:v>-23.063978245606062</c:v>
                      </c:pt>
                      <c:pt idx="135">
                        <c:v>-46.400672105371214</c:v>
                      </c:pt>
                      <c:pt idx="136">
                        <c:v>-116.57742035133417</c:v>
                      </c:pt>
                      <c:pt idx="137">
                        <c:v>85.984813509314336</c:v>
                      </c:pt>
                      <c:pt idx="138">
                        <c:v>124.19019035160538</c:v>
                      </c:pt>
                      <c:pt idx="139">
                        <c:v>129.59086245689176</c:v>
                      </c:pt>
                      <c:pt idx="140">
                        <c:v>53.112770000356619</c:v>
                      </c:pt>
                      <c:pt idx="141">
                        <c:v>-3.9612898244606112</c:v>
                      </c:pt>
                      <c:pt idx="142">
                        <c:v>49.112770000356626</c:v>
                      </c:pt>
                      <c:pt idx="143">
                        <c:v>103.35349649183992</c:v>
                      </c:pt>
                      <c:pt idx="144">
                        <c:v>145.62621210608424</c:v>
                      </c:pt>
                      <c:pt idx="145">
                        <c:v>60.580780877596112</c:v>
                      </c:pt>
                      <c:pt idx="146">
                        <c:v>123.28951824631926</c:v>
                      </c:pt>
                      <c:pt idx="147">
                        <c:v>100.61949105322056</c:v>
                      </c:pt>
                      <c:pt idx="148">
                        <c:v>101.28615771988724</c:v>
                      </c:pt>
                      <c:pt idx="149">
                        <c:v>114.28615771988719</c:v>
                      </c:pt>
                      <c:pt idx="150">
                        <c:v>30.538710175539556</c:v>
                      </c:pt>
                      <c:pt idx="151">
                        <c:v>49.205376842206157</c:v>
                      </c:pt>
                      <c:pt idx="152">
                        <c:v>164.78279719345517</c:v>
                      </c:pt>
                      <c:pt idx="153">
                        <c:v>122.19529526290984</c:v>
                      </c:pt>
                      <c:pt idx="154">
                        <c:v>240.57916473603549</c:v>
                      </c:pt>
                      <c:pt idx="155">
                        <c:v>153.84354315585563</c:v>
                      </c:pt>
                      <c:pt idx="156">
                        <c:v>-252.59247859862128</c:v>
                      </c:pt>
                      <c:pt idx="157">
                        <c:v>95.697039647781182</c:v>
                      </c:pt>
                      <c:pt idx="158">
                        <c:v>401.68870245335717</c:v>
                      </c:pt>
                      <c:pt idx="159">
                        <c:v>978.66853929475883</c:v>
                      </c:pt>
                      <c:pt idx="160">
                        <c:v>1064.2425991195767</c:v>
                      </c:pt>
                      <c:pt idx="161">
                        <c:v>672.47324403176833</c:v>
                      </c:pt>
                      <c:pt idx="162">
                        <c:v>563.36209017288627</c:v>
                      </c:pt>
                      <c:pt idx="163">
                        <c:v>649.75429684043638</c:v>
                      </c:pt>
                      <c:pt idx="164">
                        <c:v>607.46303420916024</c:v>
                      </c:pt>
                      <c:pt idx="165">
                        <c:v>414.53373350754555</c:v>
                      </c:pt>
                      <c:pt idx="166">
                        <c:v>428.51518649051343</c:v>
                      </c:pt>
                      <c:pt idx="167">
                        <c:v>245.37714842017567</c:v>
                      </c:pt>
                      <c:pt idx="168">
                        <c:v>234.30470473691901</c:v>
                      </c:pt>
                      <c:pt idx="169">
                        <c:v>194.92083526379287</c:v>
                      </c:pt>
                      <c:pt idx="170">
                        <c:v>121.11277000035638</c:v>
                      </c:pt>
                      <c:pt idx="171">
                        <c:v>120.17338771944524</c:v>
                      </c:pt>
                      <c:pt idx="172">
                        <c:v>140.91075368449711</c:v>
                      </c:pt>
                      <c:pt idx="173">
                        <c:v>-15.038710175709763</c:v>
                      </c:pt>
                      <c:pt idx="174">
                        <c:v>0</c:v>
                      </c:pt>
                      <c:pt idx="175">
                        <c:v>112.8501359654083</c:v>
                      </c:pt>
                      <c:pt idx="176">
                        <c:v>161.55887333413114</c:v>
                      </c:pt>
                      <c:pt idx="177">
                        <c:v>145.59086245689161</c:v>
                      </c:pt>
                      <c:pt idx="178">
                        <c:v>101.28615771988721</c:v>
                      </c:pt>
                      <c:pt idx="179">
                        <c:v>122.45618491298553</c:v>
                      </c:pt>
                      <c:pt idx="180">
                        <c:v>110.98817403574628</c:v>
                      </c:pt>
                      <c:pt idx="181">
                        <c:v>68.215458421502177</c:v>
                      </c:pt>
                      <c:pt idx="182">
                        <c:v>62.314786316215901</c:v>
                      </c:pt>
                      <c:pt idx="183">
                        <c:v>-13.262634035033321</c:v>
                      </c:pt>
                      <c:pt idx="184">
                        <c:v>-117.07742035133396</c:v>
                      </c:pt>
                      <c:pt idx="185">
                        <c:v>-111.84341491271454</c:v>
                      </c:pt>
                      <c:pt idx="186">
                        <c:v>-23.063978245606062</c:v>
                      </c:pt>
                      <c:pt idx="187">
                        <c:v>-46.400672105371214</c:v>
                      </c:pt>
                      <c:pt idx="188">
                        <c:v>-116.57742035133417</c:v>
                      </c:pt>
                      <c:pt idx="189">
                        <c:v>85.984813509314336</c:v>
                      </c:pt>
                      <c:pt idx="190">
                        <c:v>124.19019035160538</c:v>
                      </c:pt>
                      <c:pt idx="191">
                        <c:v>129.59086245689176</c:v>
                      </c:pt>
                      <c:pt idx="192">
                        <c:v>53.112770000356619</c:v>
                      </c:pt>
                      <c:pt idx="193">
                        <c:v>-3.9612898244606112</c:v>
                      </c:pt>
                      <c:pt idx="194">
                        <c:v>49.112770000356626</c:v>
                      </c:pt>
                      <c:pt idx="195">
                        <c:v>103.35349649183992</c:v>
                      </c:pt>
                      <c:pt idx="196">
                        <c:v>145.62621210608424</c:v>
                      </c:pt>
                      <c:pt idx="197">
                        <c:v>60.580780877596112</c:v>
                      </c:pt>
                      <c:pt idx="198">
                        <c:v>123.28951824631926</c:v>
                      </c:pt>
                      <c:pt idx="199">
                        <c:v>100.61949105322056</c:v>
                      </c:pt>
                      <c:pt idx="200">
                        <c:v>101.28615771988724</c:v>
                      </c:pt>
                      <c:pt idx="201">
                        <c:v>114.28615771988719</c:v>
                      </c:pt>
                      <c:pt idx="202">
                        <c:v>30.538710175539556</c:v>
                      </c:pt>
                      <c:pt idx="203">
                        <c:v>49.205376842206157</c:v>
                      </c:pt>
                      <c:pt idx="204">
                        <c:v>164.78279719345517</c:v>
                      </c:pt>
                      <c:pt idx="205">
                        <c:v>122.19529526290984</c:v>
                      </c:pt>
                      <c:pt idx="206">
                        <c:v>240.57916473603549</c:v>
                      </c:pt>
                      <c:pt idx="207">
                        <c:v>153.84354315585563</c:v>
                      </c:pt>
                      <c:pt idx="208">
                        <c:v>-441.49315070390793</c:v>
                      </c:pt>
                      <c:pt idx="209">
                        <c:v>-252.59247859862128</c:v>
                      </c:pt>
                      <c:pt idx="210">
                        <c:v>95.697039647781182</c:v>
                      </c:pt>
                      <c:pt idx="211">
                        <c:v>401.68870245335717</c:v>
                      </c:pt>
                      <c:pt idx="212">
                        <c:v>978.66853929475883</c:v>
                      </c:pt>
                      <c:pt idx="213">
                        <c:v>1064.2425991195767</c:v>
                      </c:pt>
                      <c:pt idx="214">
                        <c:v>672.47324403176833</c:v>
                      </c:pt>
                      <c:pt idx="215">
                        <c:v>563.36209017288627</c:v>
                      </c:pt>
                      <c:pt idx="216">
                        <c:v>649.75429684043638</c:v>
                      </c:pt>
                      <c:pt idx="217">
                        <c:v>607.46303420916024</c:v>
                      </c:pt>
                      <c:pt idx="218">
                        <c:v>414.53373350754555</c:v>
                      </c:pt>
                      <c:pt idx="219">
                        <c:v>428.51518649051343</c:v>
                      </c:pt>
                      <c:pt idx="220">
                        <c:v>245.37714842017567</c:v>
                      </c:pt>
                      <c:pt idx="221">
                        <c:v>234.30470473691901</c:v>
                      </c:pt>
                      <c:pt idx="222">
                        <c:v>194.92083526379287</c:v>
                      </c:pt>
                      <c:pt idx="223">
                        <c:v>121.11277000035638</c:v>
                      </c:pt>
                      <c:pt idx="224">
                        <c:v>120.17338771944524</c:v>
                      </c:pt>
                      <c:pt idx="225">
                        <c:v>140.91075368449711</c:v>
                      </c:pt>
                      <c:pt idx="226">
                        <c:v>-15.038710175709763</c:v>
                      </c:pt>
                      <c:pt idx="227">
                        <c:v>0</c:v>
                      </c:pt>
                      <c:pt idx="228">
                        <c:v>112.8501359654083</c:v>
                      </c:pt>
                      <c:pt idx="229">
                        <c:v>161.55887333413114</c:v>
                      </c:pt>
                      <c:pt idx="230">
                        <c:v>145.59086245689161</c:v>
                      </c:pt>
                      <c:pt idx="231">
                        <c:v>101.28615771988721</c:v>
                      </c:pt>
                      <c:pt idx="232">
                        <c:v>122.45618491298553</c:v>
                      </c:pt>
                      <c:pt idx="233">
                        <c:v>110.98817403574628</c:v>
                      </c:pt>
                      <c:pt idx="234">
                        <c:v>68.215458421502177</c:v>
                      </c:pt>
                      <c:pt idx="235">
                        <c:v>62.314786316215901</c:v>
                      </c:pt>
                      <c:pt idx="236">
                        <c:v>-13.262634035033321</c:v>
                      </c:pt>
                      <c:pt idx="237">
                        <c:v>-117.07742035133396</c:v>
                      </c:pt>
                      <c:pt idx="238">
                        <c:v>-111.84341491271454</c:v>
                      </c:pt>
                      <c:pt idx="239">
                        <c:v>-23.063978245606062</c:v>
                      </c:pt>
                      <c:pt idx="240">
                        <c:v>-46.400672105371214</c:v>
                      </c:pt>
                      <c:pt idx="241">
                        <c:v>-116.57742035133417</c:v>
                      </c:pt>
                      <c:pt idx="242">
                        <c:v>85.984813509314336</c:v>
                      </c:pt>
                      <c:pt idx="243">
                        <c:v>124.19019035160538</c:v>
                      </c:pt>
                      <c:pt idx="244">
                        <c:v>129.59086245689176</c:v>
                      </c:pt>
                      <c:pt idx="245">
                        <c:v>53.112770000356619</c:v>
                      </c:pt>
                      <c:pt idx="246">
                        <c:v>-3.9612898244606112</c:v>
                      </c:pt>
                      <c:pt idx="247">
                        <c:v>49.112770000356626</c:v>
                      </c:pt>
                      <c:pt idx="248">
                        <c:v>103.35349649183992</c:v>
                      </c:pt>
                      <c:pt idx="249">
                        <c:v>145.62621210608424</c:v>
                      </c:pt>
                      <c:pt idx="250">
                        <c:v>60.580780877596112</c:v>
                      </c:pt>
                      <c:pt idx="251">
                        <c:v>123.28951824631926</c:v>
                      </c:pt>
                      <c:pt idx="252">
                        <c:v>100.61949105322056</c:v>
                      </c:pt>
                      <c:pt idx="253">
                        <c:v>101.28615771988724</c:v>
                      </c:pt>
                      <c:pt idx="254">
                        <c:v>114.28615771988719</c:v>
                      </c:pt>
                      <c:pt idx="255">
                        <c:v>30.538710175539556</c:v>
                      </c:pt>
                      <c:pt idx="256">
                        <c:v>49.205376842206157</c:v>
                      </c:pt>
                      <c:pt idx="257">
                        <c:v>164.78279719345517</c:v>
                      </c:pt>
                      <c:pt idx="258">
                        <c:v>122.19529526290984</c:v>
                      </c:pt>
                      <c:pt idx="259">
                        <c:v>240.57916473603549</c:v>
                      </c:pt>
                      <c:pt idx="260">
                        <c:v>153.84354315585563</c:v>
                      </c:pt>
                      <c:pt idx="261">
                        <c:v>-252.59247859862128</c:v>
                      </c:pt>
                      <c:pt idx="262">
                        <c:v>95.697039647781182</c:v>
                      </c:pt>
                      <c:pt idx="263">
                        <c:v>401.68870245335717</c:v>
                      </c:pt>
                      <c:pt idx="264">
                        <c:v>978.66853929475883</c:v>
                      </c:pt>
                      <c:pt idx="265">
                        <c:v>1064.2425991195767</c:v>
                      </c:pt>
                      <c:pt idx="266">
                        <c:v>672.47324403176833</c:v>
                      </c:pt>
                      <c:pt idx="267">
                        <c:v>563.36209017288627</c:v>
                      </c:pt>
                      <c:pt idx="268">
                        <c:v>649.75429684043638</c:v>
                      </c:pt>
                      <c:pt idx="269">
                        <c:v>607.46303420916024</c:v>
                      </c:pt>
                      <c:pt idx="270">
                        <c:v>414.53373350754555</c:v>
                      </c:pt>
                      <c:pt idx="271">
                        <c:v>428.51518649051343</c:v>
                      </c:pt>
                      <c:pt idx="272">
                        <c:v>245.37714842017567</c:v>
                      </c:pt>
                      <c:pt idx="273">
                        <c:v>234.30470473691901</c:v>
                      </c:pt>
                      <c:pt idx="274">
                        <c:v>194.92083526379287</c:v>
                      </c:pt>
                      <c:pt idx="275">
                        <c:v>121.11277000035638</c:v>
                      </c:pt>
                      <c:pt idx="276">
                        <c:v>120.17338771944524</c:v>
                      </c:pt>
                      <c:pt idx="277">
                        <c:v>140.91075368449711</c:v>
                      </c:pt>
                      <c:pt idx="278">
                        <c:v>-15.038710175709763</c:v>
                      </c:pt>
                      <c:pt idx="279">
                        <c:v>0</c:v>
                      </c:pt>
                      <c:pt idx="280">
                        <c:v>112.8501359654083</c:v>
                      </c:pt>
                      <c:pt idx="281">
                        <c:v>161.55887333413114</c:v>
                      </c:pt>
                      <c:pt idx="282">
                        <c:v>145.59086245689161</c:v>
                      </c:pt>
                      <c:pt idx="283">
                        <c:v>101.28615771988721</c:v>
                      </c:pt>
                      <c:pt idx="284">
                        <c:v>122.45618491298553</c:v>
                      </c:pt>
                      <c:pt idx="285">
                        <c:v>110.98817403574628</c:v>
                      </c:pt>
                      <c:pt idx="286">
                        <c:v>68.215458421502177</c:v>
                      </c:pt>
                      <c:pt idx="287">
                        <c:v>62.314786316215901</c:v>
                      </c:pt>
                      <c:pt idx="288">
                        <c:v>-13.262634035033321</c:v>
                      </c:pt>
                      <c:pt idx="289">
                        <c:v>-117.07742035133396</c:v>
                      </c:pt>
                      <c:pt idx="290">
                        <c:v>-111.84341491271454</c:v>
                      </c:pt>
                      <c:pt idx="291">
                        <c:v>-23.063978245606062</c:v>
                      </c:pt>
                      <c:pt idx="292">
                        <c:v>-46.400672105371214</c:v>
                      </c:pt>
                      <c:pt idx="293">
                        <c:v>-116.57742035133417</c:v>
                      </c:pt>
                      <c:pt idx="294">
                        <c:v>85.984813509314336</c:v>
                      </c:pt>
                      <c:pt idx="295">
                        <c:v>124.19019035160538</c:v>
                      </c:pt>
                      <c:pt idx="296">
                        <c:v>129.59086245689176</c:v>
                      </c:pt>
                      <c:pt idx="297">
                        <c:v>53.112770000356619</c:v>
                      </c:pt>
                      <c:pt idx="298">
                        <c:v>-3.9612898244606112</c:v>
                      </c:pt>
                      <c:pt idx="299">
                        <c:v>49.112770000356626</c:v>
                      </c:pt>
                      <c:pt idx="300">
                        <c:v>103.35349649183992</c:v>
                      </c:pt>
                      <c:pt idx="301">
                        <c:v>145.62621210608424</c:v>
                      </c:pt>
                      <c:pt idx="302">
                        <c:v>60.580780877596112</c:v>
                      </c:pt>
                      <c:pt idx="303">
                        <c:v>123.28951824631926</c:v>
                      </c:pt>
                      <c:pt idx="304">
                        <c:v>100.61949105322056</c:v>
                      </c:pt>
                      <c:pt idx="305">
                        <c:v>101.28615771988724</c:v>
                      </c:pt>
                      <c:pt idx="306">
                        <c:v>114.28615771988719</c:v>
                      </c:pt>
                      <c:pt idx="307">
                        <c:v>30.538710175539556</c:v>
                      </c:pt>
                      <c:pt idx="308">
                        <c:v>49.205376842206157</c:v>
                      </c:pt>
                      <c:pt idx="309">
                        <c:v>164.78279719345517</c:v>
                      </c:pt>
                      <c:pt idx="310">
                        <c:v>122.19529526290984</c:v>
                      </c:pt>
                      <c:pt idx="311">
                        <c:v>240.57916473603549</c:v>
                      </c:pt>
                      <c:pt idx="312">
                        <c:v>153.84354315585563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1B3D-4EC0-A8D6-5E64F831BF17}"/>
                  </c:ext>
                </c:extLst>
              </c15:ser>
            </c15:filteredLineSeries>
          </c:ext>
        </c:extLst>
      </c:lineChart>
      <c:catAx>
        <c:axId val="1627113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6116352"/>
        <c:crosses val="autoZero"/>
        <c:auto val="1"/>
        <c:lblAlgn val="ctr"/>
        <c:lblOffset val="100"/>
        <c:noMultiLvlLbl val="0"/>
      </c:catAx>
      <c:valAx>
        <c:axId val="1626116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 of influenza case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7113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405946173085094"/>
          <c:y val="0.87306911636045492"/>
          <c:w val="0.3543453786150203"/>
          <c:h val="0.117671624380285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701</cdr:x>
      <cdr:y>0.01822</cdr:y>
    </cdr:from>
    <cdr:to>
      <cdr:x>0.9879</cdr:x>
      <cdr:y>0.07407</cdr:y>
    </cdr:to>
    <cdr:sp macro="" textlink="">
      <cdr:nvSpPr>
        <cdr:cNvPr id="2" name="タイトル 2"/>
        <cdr:cNvSpPr>
          <a:spLocks xmlns:a="http://schemas.openxmlformats.org/drawingml/2006/main" noGrp="1"/>
        </cdr:cNvSpPr>
      </cdr:nvSpPr>
      <cdr:spPr>
        <a:xfrm xmlns:a="http://schemas.openxmlformats.org/drawingml/2006/main">
          <a:off x="889000" y="124980"/>
          <a:ext cx="10515600" cy="383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horz" lIns="91440" tIns="45720" rIns="91440" bIns="45720" rtlCol="0" anchor="ctr">
          <a:normAutofit fontScale="90000"/>
        </a:bodyPr>
        <a:lstStyle xmlns:a="http://schemas.openxmlformats.org/drawingml/2006/main">
          <a:lvl1pPr algn="l" defTabSz="914400" rtl="0" eaLnBrk="1" latinLnBrk="0" hangingPunct="1">
            <a:lnSpc>
              <a:spcPct val="90000"/>
            </a:lnSpc>
            <a:spcBef>
              <a:spcPct val="0"/>
            </a:spcBef>
            <a:buNone/>
            <a:defRPr kumimoji="1" sz="4400" kern="1200">
              <a:solidFill>
                <a:schemeClr val="tx1"/>
              </a:solidFill>
              <a:latin typeface="+mj-lt"/>
              <a:ea typeface="+mj-ea"/>
              <a:cs typeface="+mj-cs"/>
            </a:defRPr>
          </a:lvl1pPr>
        </a:lstStyle>
        <a:p xmlns:a="http://schemas.openxmlformats.org/drawingml/2006/main"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Sample Figure </a:t>
          </a:r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endParaRPr kumimoji="1" lang="ja-JP" altLang="en-US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17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78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173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463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466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264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851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73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184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099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761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1081290466"/>
              </p:ext>
            </p:extLst>
          </p:nvPr>
        </p:nvGraphicFramePr>
        <p:xfrm>
          <a:off x="333375" y="0"/>
          <a:ext cx="11544299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35122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0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ayama Yusuke</dc:creator>
  <cp:lastModifiedBy>Katayama Yusuke</cp:lastModifiedBy>
  <cp:revision>7</cp:revision>
  <dcterms:created xsi:type="dcterms:W3CDTF">2020-03-26T05:47:16Z</dcterms:created>
  <dcterms:modified xsi:type="dcterms:W3CDTF">2020-03-31T06:42:46Z</dcterms:modified>
</cp:coreProperties>
</file>